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3" r:id="rId3"/>
    <p:sldId id="264" r:id="rId4"/>
    <p:sldId id="265" r:id="rId5"/>
    <p:sldId id="262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259D77D9-6728-4C0B-B2FB-384FE47140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="" xmlns:a16="http://schemas.microsoft.com/office/drawing/2014/main" id="{2A42956B-A44E-49EC-80F4-9414CB28AD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35F57175-F8F5-4FD0-8419-B1CF71C4B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4131CD8C-11C5-44BC-8B64-79B062709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367ED49F-04E4-4429-926F-374FFE880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1455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BC7A0B3F-60AA-4C82-A7EC-A5A49CB2F2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E9A01DE1-9EC4-4E1F-BD37-8CC175160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29FDBDF8-BED3-4C81-A689-53889523C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0F14AB04-63F5-4F9F-AB9B-3AEAC8BA7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160C4425-CBC6-4734-8198-296EFE525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832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="" xmlns:a16="http://schemas.microsoft.com/office/drawing/2014/main" id="{F905754C-EE67-4C57-9BFE-FA62C3E9F8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="" xmlns:a16="http://schemas.microsoft.com/office/drawing/2014/main" id="{AC85095A-4202-4522-8D9A-95937058C3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C346057A-21FA-47DC-84F0-9A1326A27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88BE2DD6-4B7C-4442-A201-95D470BE9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D2C2D0B6-8BDB-4F6F-9B00-2176B3364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9545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4B485024-244B-4C89-9443-4D76E8555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830A56DC-BECA-446F-BAA1-6ABC874A1A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3D66F232-1344-457A-8868-F9752D78B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B3FD505C-2292-40F3-A180-9B01C6A2C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7AC3160B-82FA-4529-BC13-D69947E0C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266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3E925292-3FC0-4098-BBA5-46E900B39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574F5615-8050-4D40-989B-B202BE86D5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267DF92F-E512-4BEE-B9A8-ADAC2D7DC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D5B807BD-224B-483A-9307-771EA532F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7A83E2B3-1C57-490A-87E6-20793C20F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317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4131B2E9-E850-4A8E-9B56-58E248EC13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8D7409D5-0C26-4315-BF73-CC0ACC70C1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EEB46B68-38FE-452E-9DEB-BB63FDFC73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AFEB3CAF-0721-4472-9F90-17CEA5877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D47950DE-E384-48FA-9128-F81A54823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72E4A62B-D6E7-4D4C-9774-157AB53FC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2429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7DF46BCA-082D-4A09-929D-D47DD0C7E4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F6BCD357-588E-4249-B126-386BB7F29B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="" xmlns:a16="http://schemas.microsoft.com/office/drawing/2014/main" id="{8E261744-78D5-429D-B019-6631FB6CC1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="" xmlns:a16="http://schemas.microsoft.com/office/drawing/2014/main" id="{F40A1F7F-5130-47F5-A734-2B548D2C3E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="" xmlns:a16="http://schemas.microsoft.com/office/drawing/2014/main" id="{B21A9FB2-639E-4579-87B4-74FEEEFF32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="" xmlns:a16="http://schemas.microsoft.com/office/drawing/2014/main" id="{D0CF91DD-FBB1-4ED0-866A-616E87701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="" xmlns:a16="http://schemas.microsoft.com/office/drawing/2014/main" id="{496FBF7F-678A-40D9-BD9B-5AEFCC530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="" xmlns:a16="http://schemas.microsoft.com/office/drawing/2014/main" id="{C96C4CB5-5D6B-44F1-800E-5E1D0B5196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787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0FA0CF46-0C5F-45A0-89EB-0A45DBE3D6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DA2E6F78-1519-46E2-91BB-84748A0D9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468BD17A-3D0E-4669-84AB-7E7A922AB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0E0F8A61-C4B4-4BA8-9FF7-D05B5C83C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336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="" xmlns:a16="http://schemas.microsoft.com/office/drawing/2014/main" id="{1EE85EF8-50E5-4306-A18F-B21BD1C9D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="" xmlns:a16="http://schemas.microsoft.com/office/drawing/2014/main" id="{0A6B40A7-E7C4-4BA7-915A-581357711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="" xmlns:a16="http://schemas.microsoft.com/office/drawing/2014/main" id="{F49AEFF0-23DA-417A-A9F8-447D7470E2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7559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92C83B68-9E84-4A39-845C-F730DAA8B4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="" xmlns:a16="http://schemas.microsoft.com/office/drawing/2014/main" id="{153DB8DE-53E5-496C-BC0C-0DD37333C3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BEAA81BB-4F71-42FE-99DE-0E444747EC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94B54A12-5F75-43F2-82D8-1DCC048E0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1817A6A3-1322-4F26-B876-BFB718607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3D560CE5-AE35-4D70-966B-44C0D18BA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0158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="" xmlns:a16="http://schemas.microsoft.com/office/drawing/2014/main" id="{93F87477-872A-4FB3-A6BC-D67ADACBCF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="" xmlns:a16="http://schemas.microsoft.com/office/drawing/2014/main" id="{DBD766F7-7F68-45BB-B207-B89ADF736D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="" xmlns:a16="http://schemas.microsoft.com/office/drawing/2014/main" id="{30FEE71C-F3EA-4BE0-9C05-E7A8C6AF89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="" xmlns:a16="http://schemas.microsoft.com/office/drawing/2014/main" id="{EFD5A59B-8CEE-45E2-A565-99B2639FF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="" xmlns:a16="http://schemas.microsoft.com/office/drawing/2014/main" id="{24954E46-C7D9-4904-AF54-E6A11D76F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="" xmlns:a16="http://schemas.microsoft.com/office/drawing/2014/main" id="{37EABD54-3F82-42EC-BC04-D5EEE281A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3766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="" xmlns:a16="http://schemas.microsoft.com/office/drawing/2014/main" id="{9089F699-FD61-488E-AFC3-5FFCC8C58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="" xmlns:a16="http://schemas.microsoft.com/office/drawing/2014/main" id="{04FD8B76-DB22-4316-97CF-8E5D1412F5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="" xmlns:a16="http://schemas.microsoft.com/office/drawing/2014/main" id="{3196C0D0-3C3E-4F1F-A752-B02F4DEC48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C7602-2033-49AA-86E1-6BED078EB59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="" xmlns:a16="http://schemas.microsoft.com/office/drawing/2014/main" id="{B7A85A3C-6130-4A59-B007-5025ACC099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="" xmlns:a16="http://schemas.microsoft.com/office/drawing/2014/main" id="{03F0C6C9-C9D6-47AD-9B75-66E4FD478A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30028-21D2-499C-BF71-3D31333EA1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399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男 が含まれている画像&#10;&#10;自動的に生成された説明">
            <a:extLst>
              <a:ext uri="{FF2B5EF4-FFF2-40B4-BE49-F238E27FC236}">
                <a16:creationId xmlns="" xmlns:a16="http://schemas.microsoft.com/office/drawing/2014/main" id="{4826B44B-EC4F-4B47-BB4E-847B7990F96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22" t="29771" r="21671" b="28203"/>
          <a:stretch/>
        </p:blipFill>
        <p:spPr>
          <a:xfrm>
            <a:off x="4452839" y="2238587"/>
            <a:ext cx="3006533" cy="2915598"/>
          </a:xfrm>
          <a:prstGeom prst="rect">
            <a:avLst/>
          </a:prstGeom>
        </p:spPr>
      </p:pic>
      <p:pic>
        <p:nvPicPr>
          <p:cNvPr id="4" name="図 3" descr="写真, 線画, 煙, 光 が含まれている画像&#10;&#10;自動的に生成された説明">
            <a:extLst>
              <a:ext uri="{FF2B5EF4-FFF2-40B4-BE49-F238E27FC236}">
                <a16:creationId xmlns="" xmlns:a16="http://schemas.microsoft.com/office/drawing/2014/main" id="{42FD0ACE-56DB-4682-9176-7BDF904A670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47" t="27100" r="22183" b="28569"/>
          <a:stretch/>
        </p:blipFill>
        <p:spPr>
          <a:xfrm>
            <a:off x="913306" y="2077217"/>
            <a:ext cx="3191097" cy="309458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="" xmlns:a16="http://schemas.microsoft.com/office/drawing/2014/main" id="{2B5EF176-72C8-4DA7-BA3A-DA0B9F383602}"/>
              </a:ext>
            </a:extLst>
          </p:cNvPr>
          <p:cNvSpPr txBox="1"/>
          <p:nvPr/>
        </p:nvSpPr>
        <p:spPr>
          <a:xfrm>
            <a:off x="240831" y="224377"/>
            <a:ext cx="19538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ja-JP" alt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3E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="" xmlns:a16="http://schemas.microsoft.com/office/drawing/2014/main" id="{F657C627-40B3-47A8-AE52-38F6E86FF34D}"/>
              </a:ext>
            </a:extLst>
          </p:cNvPr>
          <p:cNvSpPr/>
          <p:nvPr/>
        </p:nvSpPr>
        <p:spPr>
          <a:xfrm>
            <a:off x="2577737" y="3338544"/>
            <a:ext cx="576500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="" xmlns:a16="http://schemas.microsoft.com/office/drawing/2014/main" id="{8D7173F0-F06B-44A8-98B8-EFE2DD2AD9DD}"/>
              </a:ext>
            </a:extLst>
          </p:cNvPr>
          <p:cNvSpPr txBox="1"/>
          <p:nvPr/>
        </p:nvSpPr>
        <p:spPr>
          <a:xfrm>
            <a:off x="8292149" y="2747344"/>
            <a:ext cx="1488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aved PARP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="" xmlns:a16="http://schemas.microsoft.com/office/drawing/2014/main" id="{FE80500D-1148-4126-96DE-2B4D09C16265}"/>
              </a:ext>
            </a:extLst>
          </p:cNvPr>
          <p:cNvSpPr txBox="1"/>
          <p:nvPr/>
        </p:nvSpPr>
        <p:spPr>
          <a:xfrm>
            <a:off x="7788022" y="2747344"/>
            <a:ext cx="798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9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="" xmlns:a16="http://schemas.microsoft.com/office/drawing/2014/main" id="{27D890F5-4419-48A6-B8C1-E4A37CDE511D}"/>
              </a:ext>
            </a:extLst>
          </p:cNvPr>
          <p:cNvSpPr txBox="1"/>
          <p:nvPr/>
        </p:nvSpPr>
        <p:spPr>
          <a:xfrm>
            <a:off x="8270952" y="3341749"/>
            <a:ext cx="10115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="" xmlns:a16="http://schemas.microsoft.com/office/drawing/2014/main" id="{5F4E5AB9-764A-4218-BFDD-DD4F7651F628}"/>
              </a:ext>
            </a:extLst>
          </p:cNvPr>
          <p:cNvSpPr txBox="1"/>
          <p:nvPr/>
        </p:nvSpPr>
        <p:spPr>
          <a:xfrm>
            <a:off x="7795426" y="3341749"/>
            <a:ext cx="798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8B394FD4-3501-4657-8304-9A45BB614913}"/>
              </a:ext>
            </a:extLst>
          </p:cNvPr>
          <p:cNvSpPr txBox="1"/>
          <p:nvPr/>
        </p:nvSpPr>
        <p:spPr>
          <a:xfrm>
            <a:off x="957775" y="5397350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5sec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="" xmlns:a16="http://schemas.microsoft.com/office/drawing/2014/main" id="{FB65F559-E515-4087-90BD-FBE48A4ACBA8}"/>
              </a:ext>
            </a:extLst>
          </p:cNvPr>
          <p:cNvSpPr txBox="1"/>
          <p:nvPr/>
        </p:nvSpPr>
        <p:spPr>
          <a:xfrm>
            <a:off x="4565290" y="5386636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1m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="" xmlns:a16="http://schemas.microsoft.com/office/drawing/2014/main" id="{82189CBA-BE85-4D46-BBEF-5A84EA375EC8}"/>
              </a:ext>
            </a:extLst>
          </p:cNvPr>
          <p:cNvSpPr/>
          <p:nvPr/>
        </p:nvSpPr>
        <p:spPr>
          <a:xfrm>
            <a:off x="3148153" y="3338544"/>
            <a:ext cx="576500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="" xmlns:a16="http://schemas.microsoft.com/office/drawing/2014/main" id="{F795F6C0-C1C7-45C6-89FB-2079C95DE008}"/>
              </a:ext>
            </a:extLst>
          </p:cNvPr>
          <p:cNvSpPr/>
          <p:nvPr/>
        </p:nvSpPr>
        <p:spPr>
          <a:xfrm>
            <a:off x="5961525" y="2646036"/>
            <a:ext cx="525272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="" xmlns:a16="http://schemas.microsoft.com/office/drawing/2014/main" id="{C453D9F7-EBE7-43C5-B64E-7B381E75820F}"/>
              </a:ext>
            </a:extLst>
          </p:cNvPr>
          <p:cNvSpPr/>
          <p:nvPr/>
        </p:nvSpPr>
        <p:spPr>
          <a:xfrm>
            <a:off x="6479695" y="2646036"/>
            <a:ext cx="525272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67" name="グループ化 66">
            <a:extLst>
              <a:ext uri="{FF2B5EF4-FFF2-40B4-BE49-F238E27FC236}">
                <a16:creationId xmlns="" xmlns:a16="http://schemas.microsoft.com/office/drawing/2014/main" id="{0646DEA9-D367-4A7D-BCAE-E0F76CF69B8F}"/>
              </a:ext>
            </a:extLst>
          </p:cNvPr>
          <p:cNvGrpSpPr/>
          <p:nvPr/>
        </p:nvGrpSpPr>
        <p:grpSpPr>
          <a:xfrm>
            <a:off x="2539784" y="1065248"/>
            <a:ext cx="1183536" cy="869894"/>
            <a:chOff x="2599724" y="2622958"/>
            <a:chExt cx="1115504" cy="869894"/>
          </a:xfrm>
        </p:grpSpPr>
        <p:sp>
          <p:nvSpPr>
            <p:cNvPr id="21" name="テキスト ボックス 20">
              <a:extLst>
                <a:ext uri="{FF2B5EF4-FFF2-40B4-BE49-F238E27FC236}">
                  <a16:creationId xmlns="" xmlns:a16="http://schemas.microsoft.com/office/drawing/2014/main" id="{5262C6EB-0470-41DC-8AE8-F3E8480D4EBE}"/>
                </a:ext>
              </a:extLst>
            </p:cNvPr>
            <p:cNvSpPr txBox="1"/>
            <p:nvPr/>
          </p:nvSpPr>
          <p:spPr>
            <a:xfrm rot="16200000">
              <a:off x="2635602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="" xmlns:a16="http://schemas.microsoft.com/office/drawing/2014/main" id="{624A580C-20EA-46F3-BCBC-C15B8A58BC9D}"/>
                </a:ext>
              </a:extLst>
            </p:cNvPr>
            <p:cNvSpPr txBox="1"/>
            <p:nvPr/>
          </p:nvSpPr>
          <p:spPr>
            <a:xfrm rot="16200000">
              <a:off x="2461745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="" xmlns:a16="http://schemas.microsoft.com/office/drawing/2014/main" id="{671B50C5-F669-45D5-89E2-084D1BA702AD}"/>
                </a:ext>
              </a:extLst>
            </p:cNvPr>
            <p:cNvSpPr txBox="1"/>
            <p:nvPr/>
          </p:nvSpPr>
          <p:spPr>
            <a:xfrm rot="16200000">
              <a:off x="2287888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="" xmlns:a16="http://schemas.microsoft.com/office/drawing/2014/main" id="{41B99559-13B5-4D43-8497-AA47281F7D63}"/>
                </a:ext>
              </a:extLst>
            </p:cNvPr>
            <p:cNvSpPr txBox="1"/>
            <p:nvPr/>
          </p:nvSpPr>
          <p:spPr>
            <a:xfrm rot="16200000">
              <a:off x="3157171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="" xmlns:a16="http://schemas.microsoft.com/office/drawing/2014/main" id="{0E08D4C4-4BAD-439F-80CC-8BCEFC92163B}"/>
                </a:ext>
              </a:extLst>
            </p:cNvPr>
            <p:cNvSpPr txBox="1"/>
            <p:nvPr/>
          </p:nvSpPr>
          <p:spPr>
            <a:xfrm rot="16200000">
              <a:off x="2983316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="" xmlns:a16="http://schemas.microsoft.com/office/drawing/2014/main" id="{FE543880-F9E8-44A6-A484-BEC3B2AF5E25}"/>
                </a:ext>
              </a:extLst>
            </p:cNvPr>
            <p:cNvSpPr txBox="1"/>
            <p:nvPr/>
          </p:nvSpPr>
          <p:spPr>
            <a:xfrm rot="16200000">
              <a:off x="2809459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9" name="テキスト ボックス 68">
            <a:extLst>
              <a:ext uri="{FF2B5EF4-FFF2-40B4-BE49-F238E27FC236}">
                <a16:creationId xmlns="" xmlns:a16="http://schemas.microsoft.com/office/drawing/2014/main" id="{6514095D-37F4-4536-A27F-B6A2F5DE31B9}"/>
              </a:ext>
            </a:extLst>
          </p:cNvPr>
          <p:cNvSpPr txBox="1"/>
          <p:nvPr/>
        </p:nvSpPr>
        <p:spPr>
          <a:xfrm>
            <a:off x="2492920" y="712676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線コネクタ 69">
            <a:extLst>
              <a:ext uri="{FF2B5EF4-FFF2-40B4-BE49-F238E27FC236}">
                <a16:creationId xmlns="" xmlns:a16="http://schemas.microsoft.com/office/drawing/2014/main" id="{DBA3BB03-DF4F-49FF-805D-D0C0E04A3096}"/>
              </a:ext>
            </a:extLst>
          </p:cNvPr>
          <p:cNvCxnSpPr>
            <a:cxnSpLocks/>
          </p:cNvCxnSpPr>
          <p:nvPr/>
        </p:nvCxnSpPr>
        <p:spPr>
          <a:xfrm>
            <a:off x="2619941" y="1116037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="" xmlns:a16="http://schemas.microsoft.com/office/drawing/2014/main" id="{D4091998-566C-4D60-A2B6-EF9ADB7EDB28}"/>
              </a:ext>
            </a:extLst>
          </p:cNvPr>
          <p:cNvCxnSpPr>
            <a:cxnSpLocks/>
          </p:cNvCxnSpPr>
          <p:nvPr/>
        </p:nvCxnSpPr>
        <p:spPr>
          <a:xfrm>
            <a:off x="3190686" y="1116037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="" xmlns:a16="http://schemas.microsoft.com/office/drawing/2014/main" id="{9B0F4389-D5C7-4F7F-98D1-303F9FE56C47}"/>
              </a:ext>
            </a:extLst>
          </p:cNvPr>
          <p:cNvSpPr txBox="1"/>
          <p:nvPr/>
        </p:nvSpPr>
        <p:spPr>
          <a:xfrm>
            <a:off x="3063665" y="715950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グループ化 73">
            <a:extLst>
              <a:ext uri="{FF2B5EF4-FFF2-40B4-BE49-F238E27FC236}">
                <a16:creationId xmlns="" xmlns:a16="http://schemas.microsoft.com/office/drawing/2014/main" id="{88671ABA-C7CA-4D60-BB9D-0911ACD32447}"/>
              </a:ext>
            </a:extLst>
          </p:cNvPr>
          <p:cNvGrpSpPr/>
          <p:nvPr/>
        </p:nvGrpSpPr>
        <p:grpSpPr>
          <a:xfrm>
            <a:off x="5895390" y="1065248"/>
            <a:ext cx="1183536" cy="869894"/>
            <a:chOff x="2599724" y="2622958"/>
            <a:chExt cx="1115504" cy="869894"/>
          </a:xfrm>
        </p:grpSpPr>
        <p:sp>
          <p:nvSpPr>
            <p:cNvPr id="75" name="テキスト ボックス 74">
              <a:extLst>
                <a:ext uri="{FF2B5EF4-FFF2-40B4-BE49-F238E27FC236}">
                  <a16:creationId xmlns="" xmlns:a16="http://schemas.microsoft.com/office/drawing/2014/main" id="{C72C6DAC-A191-49A1-9801-5C9A208115B3}"/>
                </a:ext>
              </a:extLst>
            </p:cNvPr>
            <p:cNvSpPr txBox="1"/>
            <p:nvPr/>
          </p:nvSpPr>
          <p:spPr>
            <a:xfrm rot="16200000">
              <a:off x="2635602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="" xmlns:a16="http://schemas.microsoft.com/office/drawing/2014/main" id="{753866CA-FEAA-46EC-9E50-5B2C0F122D4C}"/>
                </a:ext>
              </a:extLst>
            </p:cNvPr>
            <p:cNvSpPr txBox="1"/>
            <p:nvPr/>
          </p:nvSpPr>
          <p:spPr>
            <a:xfrm rot="16200000">
              <a:off x="2461745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="" xmlns:a16="http://schemas.microsoft.com/office/drawing/2014/main" id="{4D7768E2-BCCC-4D4B-B9C1-81E8BE2DA502}"/>
                </a:ext>
              </a:extLst>
            </p:cNvPr>
            <p:cNvSpPr txBox="1"/>
            <p:nvPr/>
          </p:nvSpPr>
          <p:spPr>
            <a:xfrm rot="16200000">
              <a:off x="2287888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="" xmlns:a16="http://schemas.microsoft.com/office/drawing/2014/main" id="{EE81F1C6-1AF2-443F-864F-92C406EF1206}"/>
                </a:ext>
              </a:extLst>
            </p:cNvPr>
            <p:cNvSpPr txBox="1"/>
            <p:nvPr/>
          </p:nvSpPr>
          <p:spPr>
            <a:xfrm rot="16200000">
              <a:off x="3157171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iR-486-5p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="" xmlns:a16="http://schemas.microsoft.com/office/drawing/2014/main" id="{AB655BEE-DCD3-4165-AD93-B12C14E4D6FF}"/>
                </a:ext>
              </a:extLst>
            </p:cNvPr>
            <p:cNvSpPr txBox="1"/>
            <p:nvPr/>
          </p:nvSpPr>
          <p:spPr>
            <a:xfrm rot="16200000">
              <a:off x="2983316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="" xmlns:a16="http://schemas.microsoft.com/office/drawing/2014/main" id="{69BB8B24-7897-46E3-8575-E0ADA7344F8F}"/>
                </a:ext>
              </a:extLst>
            </p:cNvPr>
            <p:cNvSpPr txBox="1"/>
            <p:nvPr/>
          </p:nvSpPr>
          <p:spPr>
            <a:xfrm rot="16200000">
              <a:off x="2809459" y="2934794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1" name="テキスト ボックス 80">
            <a:extLst>
              <a:ext uri="{FF2B5EF4-FFF2-40B4-BE49-F238E27FC236}">
                <a16:creationId xmlns="" xmlns:a16="http://schemas.microsoft.com/office/drawing/2014/main" id="{8CBBDAFB-6B10-4875-BF8A-51AC439A5EA4}"/>
              </a:ext>
            </a:extLst>
          </p:cNvPr>
          <p:cNvSpPr txBox="1"/>
          <p:nvPr/>
        </p:nvSpPr>
        <p:spPr>
          <a:xfrm>
            <a:off x="5848526" y="712676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="" xmlns:a16="http://schemas.microsoft.com/office/drawing/2014/main" id="{69BFB1D0-9ADD-4DF7-9752-025A113F4F9D}"/>
              </a:ext>
            </a:extLst>
          </p:cNvPr>
          <p:cNvCxnSpPr>
            <a:cxnSpLocks/>
          </p:cNvCxnSpPr>
          <p:nvPr/>
        </p:nvCxnSpPr>
        <p:spPr>
          <a:xfrm>
            <a:off x="5975547" y="1116037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="" xmlns:a16="http://schemas.microsoft.com/office/drawing/2014/main" id="{071D8F7C-70EE-44B5-A157-A80871F8F0EB}"/>
              </a:ext>
            </a:extLst>
          </p:cNvPr>
          <p:cNvCxnSpPr>
            <a:cxnSpLocks/>
          </p:cNvCxnSpPr>
          <p:nvPr/>
        </p:nvCxnSpPr>
        <p:spPr>
          <a:xfrm>
            <a:off x="6546292" y="1116037"/>
            <a:ext cx="46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A2AF7B8B-7178-4B1D-9B0E-B3D420F5CB55}"/>
              </a:ext>
            </a:extLst>
          </p:cNvPr>
          <p:cNvSpPr txBox="1"/>
          <p:nvPr/>
        </p:nvSpPr>
        <p:spPr>
          <a:xfrm>
            <a:off x="6419271" y="715950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="" xmlns:a16="http://schemas.microsoft.com/office/drawing/2014/main" id="{8A348120-D335-42F3-8211-E8397E85821E}"/>
              </a:ext>
            </a:extLst>
          </p:cNvPr>
          <p:cNvSpPr txBox="1"/>
          <p:nvPr/>
        </p:nvSpPr>
        <p:spPr>
          <a:xfrm>
            <a:off x="8292149" y="2507536"/>
            <a:ext cx="1488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="" xmlns:a16="http://schemas.microsoft.com/office/drawing/2014/main" id="{B8341177-3900-498A-976B-9B9A3732E07C}"/>
              </a:ext>
            </a:extLst>
          </p:cNvPr>
          <p:cNvSpPr txBox="1"/>
          <p:nvPr/>
        </p:nvSpPr>
        <p:spPr>
          <a:xfrm>
            <a:off x="7716302" y="2507536"/>
            <a:ext cx="798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6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82956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="" xmlns:a16="http://schemas.microsoft.com/office/drawing/2014/main" id="{C56413ED-DF66-4283-944B-403E25F1CB20}"/>
              </a:ext>
            </a:extLst>
          </p:cNvPr>
          <p:cNvSpPr txBox="1"/>
          <p:nvPr/>
        </p:nvSpPr>
        <p:spPr>
          <a:xfrm>
            <a:off x="228728" y="218813"/>
            <a:ext cx="18102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 descr="写真, ホワイト, 座る, 大きい が含まれている画像&#10;&#10;自動的に生成された説明">
            <a:extLst>
              <a:ext uri="{FF2B5EF4-FFF2-40B4-BE49-F238E27FC236}">
                <a16:creationId xmlns="" xmlns:a16="http://schemas.microsoft.com/office/drawing/2014/main" id="{0DCB51C8-1801-46C4-8F56-84B81FA4FF6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74" t="28682" r="26498" b="26743"/>
          <a:stretch/>
        </p:blipFill>
        <p:spPr>
          <a:xfrm>
            <a:off x="1038687" y="2016914"/>
            <a:ext cx="2902998" cy="28746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 descr="屋内, 探す, ホワイト, 冷蔵庫 が含まれている画像&#10;&#10;自動的に生成された説明">
            <a:extLst>
              <a:ext uri="{FF2B5EF4-FFF2-40B4-BE49-F238E27FC236}">
                <a16:creationId xmlns="" xmlns:a16="http://schemas.microsoft.com/office/drawing/2014/main" id="{D2513290-1490-4CAC-9355-1C99DFD0B83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31" t="29319" r="27362" b="26296"/>
          <a:stretch/>
        </p:blipFill>
        <p:spPr>
          <a:xfrm>
            <a:off x="4653645" y="2013818"/>
            <a:ext cx="2902998" cy="28689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正方形/長方形 14">
            <a:extLst>
              <a:ext uri="{FF2B5EF4-FFF2-40B4-BE49-F238E27FC236}">
                <a16:creationId xmlns="" xmlns:a16="http://schemas.microsoft.com/office/drawing/2014/main" id="{6E6CDCC5-0B59-4B62-A7F9-354244F56E60}"/>
              </a:ext>
            </a:extLst>
          </p:cNvPr>
          <p:cNvSpPr/>
          <p:nvPr/>
        </p:nvSpPr>
        <p:spPr>
          <a:xfrm>
            <a:off x="1529224" y="3286648"/>
            <a:ext cx="1089690" cy="3196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A44F3C78-623A-4222-B32A-0858594D21A3}"/>
              </a:ext>
            </a:extLst>
          </p:cNvPr>
          <p:cNvSpPr txBox="1"/>
          <p:nvPr/>
        </p:nvSpPr>
        <p:spPr>
          <a:xfrm>
            <a:off x="8123908" y="3286648"/>
            <a:ext cx="951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="" xmlns:a16="http://schemas.microsoft.com/office/drawing/2014/main" id="{4B14597A-CCB7-45E2-B244-0D38227A94E7}"/>
              </a:ext>
            </a:extLst>
          </p:cNvPr>
          <p:cNvSpPr txBox="1"/>
          <p:nvPr/>
        </p:nvSpPr>
        <p:spPr>
          <a:xfrm>
            <a:off x="7577358" y="3286648"/>
            <a:ext cx="75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07E28158-FF07-4547-86C5-07ADDC453D8E}"/>
              </a:ext>
            </a:extLst>
          </p:cNvPr>
          <p:cNvSpPr txBox="1"/>
          <p:nvPr/>
        </p:nvSpPr>
        <p:spPr>
          <a:xfrm>
            <a:off x="8144368" y="2855310"/>
            <a:ext cx="98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HHADH</a:t>
            </a:r>
            <a:endParaRPr lang="ja-JP" altLang="en-US" sz="1200" b="1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="" xmlns:a16="http://schemas.microsoft.com/office/drawing/2014/main" id="{41A34721-CB08-451D-BCFD-4AB1693287C5}"/>
              </a:ext>
            </a:extLst>
          </p:cNvPr>
          <p:cNvSpPr txBox="1"/>
          <p:nvPr/>
        </p:nvSpPr>
        <p:spPr>
          <a:xfrm>
            <a:off x="7578830" y="2855310"/>
            <a:ext cx="75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9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="" xmlns:a16="http://schemas.microsoft.com/office/drawing/2014/main" id="{E4E45715-E5C7-48A2-8ADF-0116FB188970}"/>
              </a:ext>
            </a:extLst>
          </p:cNvPr>
          <p:cNvSpPr txBox="1"/>
          <p:nvPr/>
        </p:nvSpPr>
        <p:spPr>
          <a:xfrm>
            <a:off x="958182" y="4882720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5sec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="" xmlns:a16="http://schemas.microsoft.com/office/drawing/2014/main" id="{BBDC2BE0-F06D-431B-912B-60B3D9368C95}"/>
              </a:ext>
            </a:extLst>
          </p:cNvPr>
          <p:cNvSpPr txBox="1"/>
          <p:nvPr/>
        </p:nvSpPr>
        <p:spPr>
          <a:xfrm>
            <a:off x="4564322" y="4902376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1m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="" xmlns:a16="http://schemas.microsoft.com/office/drawing/2014/main" id="{7DBA756C-BB43-4CB8-BFD0-E20B1B60E8A1}"/>
              </a:ext>
            </a:extLst>
          </p:cNvPr>
          <p:cNvSpPr/>
          <p:nvPr/>
        </p:nvSpPr>
        <p:spPr>
          <a:xfrm>
            <a:off x="5179421" y="2844245"/>
            <a:ext cx="1089690" cy="227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1" name="グループ化 40">
            <a:extLst>
              <a:ext uri="{FF2B5EF4-FFF2-40B4-BE49-F238E27FC236}">
                <a16:creationId xmlns="" xmlns:a16="http://schemas.microsoft.com/office/drawing/2014/main" id="{F8D9C311-3697-45B0-A371-9CBA76BB49D9}"/>
              </a:ext>
            </a:extLst>
          </p:cNvPr>
          <p:cNvGrpSpPr/>
          <p:nvPr/>
        </p:nvGrpSpPr>
        <p:grpSpPr>
          <a:xfrm>
            <a:off x="1427600" y="801449"/>
            <a:ext cx="1292788" cy="1222466"/>
            <a:chOff x="2492920" y="712676"/>
            <a:chExt cx="1292788" cy="1222466"/>
          </a:xfrm>
        </p:grpSpPr>
        <p:grpSp>
          <p:nvGrpSpPr>
            <p:cNvPr id="30" name="グループ化 29">
              <a:extLst>
                <a:ext uri="{FF2B5EF4-FFF2-40B4-BE49-F238E27FC236}">
                  <a16:creationId xmlns="" xmlns:a16="http://schemas.microsoft.com/office/drawing/2014/main" id="{CA1BD4FA-3304-42CE-85D0-9FF31DCA535D}"/>
                </a:ext>
              </a:extLst>
            </p:cNvPr>
            <p:cNvGrpSpPr/>
            <p:nvPr/>
          </p:nvGrpSpPr>
          <p:grpSpPr>
            <a:xfrm>
              <a:off x="2539784" y="1065248"/>
              <a:ext cx="1183536" cy="869894"/>
              <a:chOff x="2599724" y="2622958"/>
              <a:chExt cx="1115504" cy="869894"/>
            </a:xfrm>
          </p:grpSpPr>
          <p:sp>
            <p:nvSpPr>
              <p:cNvPr id="31" name="テキスト ボックス 30">
                <a:extLst>
                  <a:ext uri="{FF2B5EF4-FFF2-40B4-BE49-F238E27FC236}">
                    <a16:creationId xmlns="" xmlns:a16="http://schemas.microsoft.com/office/drawing/2014/main" id="{5820B502-FE79-4960-B478-324996CA5081}"/>
                  </a:ext>
                </a:extLst>
              </p:cNvPr>
              <p:cNvSpPr txBox="1"/>
              <p:nvPr/>
            </p:nvSpPr>
            <p:spPr>
              <a:xfrm rot="16200000">
                <a:off x="2635602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486-5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="" xmlns:a16="http://schemas.microsoft.com/office/drawing/2014/main" id="{F98AC246-F352-48B1-ACFD-F891623E2652}"/>
                  </a:ext>
                </a:extLst>
              </p:cNvPr>
              <p:cNvSpPr txBox="1"/>
              <p:nvPr/>
            </p:nvSpPr>
            <p:spPr>
              <a:xfrm rot="16200000">
                <a:off x="2461745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control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="" xmlns:a16="http://schemas.microsoft.com/office/drawing/2014/main" id="{A29DB85A-7C6C-4883-9A3C-017D8A79EC73}"/>
                  </a:ext>
                </a:extLst>
              </p:cNvPr>
              <p:cNvSpPr txBox="1"/>
              <p:nvPr/>
            </p:nvSpPr>
            <p:spPr>
              <a:xfrm rot="16200000">
                <a:off x="2287888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="" xmlns:a16="http://schemas.microsoft.com/office/drawing/2014/main" id="{4AE37146-FD89-46B8-BE98-16A6EA786B99}"/>
                  </a:ext>
                </a:extLst>
              </p:cNvPr>
              <p:cNvSpPr txBox="1"/>
              <p:nvPr/>
            </p:nvSpPr>
            <p:spPr>
              <a:xfrm rot="16200000">
                <a:off x="3157171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486-5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="" xmlns:a16="http://schemas.microsoft.com/office/drawing/2014/main" id="{C5D99907-14FA-4651-88D8-91E39AAD13C9}"/>
                  </a:ext>
                </a:extLst>
              </p:cNvPr>
              <p:cNvSpPr txBox="1"/>
              <p:nvPr/>
            </p:nvSpPr>
            <p:spPr>
              <a:xfrm rot="16200000">
                <a:off x="2983316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control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="" xmlns:a16="http://schemas.microsoft.com/office/drawing/2014/main" id="{C97C58A5-EB98-4204-98D8-F94D2DBABF76}"/>
                  </a:ext>
                </a:extLst>
              </p:cNvPr>
              <p:cNvSpPr txBox="1"/>
              <p:nvPr/>
            </p:nvSpPr>
            <p:spPr>
              <a:xfrm rot="16200000">
                <a:off x="2809459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" name="テキスト ボックス 36">
              <a:extLst>
                <a:ext uri="{FF2B5EF4-FFF2-40B4-BE49-F238E27FC236}">
                  <a16:creationId xmlns="" xmlns:a16="http://schemas.microsoft.com/office/drawing/2014/main" id="{04CE964F-87A7-4F2A-9ED7-6B2A1A5260DD}"/>
                </a:ext>
              </a:extLst>
            </p:cNvPr>
            <p:cNvSpPr txBox="1"/>
            <p:nvPr/>
          </p:nvSpPr>
          <p:spPr>
            <a:xfrm>
              <a:off x="2492920" y="712676"/>
              <a:ext cx="7220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DP-R-</a:t>
              </a:r>
            </a:p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OY</a:t>
              </a:r>
              <a:endParaRPr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線コネクタ 37">
              <a:extLst>
                <a:ext uri="{FF2B5EF4-FFF2-40B4-BE49-F238E27FC236}">
                  <a16:creationId xmlns="" xmlns:a16="http://schemas.microsoft.com/office/drawing/2014/main" id="{5BA7891F-1C2C-4CB2-8C9B-513BB16D0FF0}"/>
                </a:ext>
              </a:extLst>
            </p:cNvPr>
            <p:cNvCxnSpPr>
              <a:cxnSpLocks/>
            </p:cNvCxnSpPr>
            <p:nvPr/>
          </p:nvCxnSpPr>
          <p:spPr>
            <a:xfrm>
              <a:off x="2619941" y="1116037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="" xmlns:a16="http://schemas.microsoft.com/office/drawing/2014/main" id="{4811E9EC-9795-4F12-B949-65FD8ACDC15B}"/>
                </a:ext>
              </a:extLst>
            </p:cNvPr>
            <p:cNvCxnSpPr>
              <a:cxnSpLocks/>
            </p:cNvCxnSpPr>
            <p:nvPr/>
          </p:nvCxnSpPr>
          <p:spPr>
            <a:xfrm>
              <a:off x="3190686" y="1116037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="" xmlns:a16="http://schemas.microsoft.com/office/drawing/2014/main" id="{F894FCD6-4315-4AA0-81F2-8031C769C11A}"/>
                </a:ext>
              </a:extLst>
            </p:cNvPr>
            <p:cNvSpPr txBox="1"/>
            <p:nvPr/>
          </p:nvSpPr>
          <p:spPr>
            <a:xfrm>
              <a:off x="3063665" y="715950"/>
              <a:ext cx="7220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DP-R-</a:t>
              </a:r>
            </a:p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24</a:t>
              </a:r>
              <a:endParaRPr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グループ化 41">
            <a:extLst>
              <a:ext uri="{FF2B5EF4-FFF2-40B4-BE49-F238E27FC236}">
                <a16:creationId xmlns="" xmlns:a16="http://schemas.microsoft.com/office/drawing/2014/main" id="{130AE6E4-17C9-4F21-9D4B-5F09096CB8D4}"/>
              </a:ext>
            </a:extLst>
          </p:cNvPr>
          <p:cNvGrpSpPr/>
          <p:nvPr/>
        </p:nvGrpSpPr>
        <p:grpSpPr>
          <a:xfrm>
            <a:off x="5082859" y="809108"/>
            <a:ext cx="1292788" cy="1222466"/>
            <a:chOff x="2492920" y="712676"/>
            <a:chExt cx="1292788" cy="1222466"/>
          </a:xfrm>
        </p:grpSpPr>
        <p:grpSp>
          <p:nvGrpSpPr>
            <p:cNvPr id="43" name="グループ化 42">
              <a:extLst>
                <a:ext uri="{FF2B5EF4-FFF2-40B4-BE49-F238E27FC236}">
                  <a16:creationId xmlns="" xmlns:a16="http://schemas.microsoft.com/office/drawing/2014/main" id="{D1485B15-D481-4250-9219-A2FED5A6F871}"/>
                </a:ext>
              </a:extLst>
            </p:cNvPr>
            <p:cNvGrpSpPr/>
            <p:nvPr/>
          </p:nvGrpSpPr>
          <p:grpSpPr>
            <a:xfrm>
              <a:off x="2539784" y="1065248"/>
              <a:ext cx="1183536" cy="869894"/>
              <a:chOff x="2599724" y="2622958"/>
              <a:chExt cx="1115504" cy="869894"/>
            </a:xfrm>
          </p:grpSpPr>
          <p:sp>
            <p:nvSpPr>
              <p:cNvPr id="48" name="テキスト ボックス 47">
                <a:extLst>
                  <a:ext uri="{FF2B5EF4-FFF2-40B4-BE49-F238E27FC236}">
                    <a16:creationId xmlns="" xmlns:a16="http://schemas.microsoft.com/office/drawing/2014/main" id="{0A60A1CC-BD80-43B0-A753-43BCC8E10FDC}"/>
                  </a:ext>
                </a:extLst>
              </p:cNvPr>
              <p:cNvSpPr txBox="1"/>
              <p:nvPr/>
            </p:nvSpPr>
            <p:spPr>
              <a:xfrm rot="16200000">
                <a:off x="2635602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486-5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="" xmlns:a16="http://schemas.microsoft.com/office/drawing/2014/main" id="{A0B41472-0F2B-4FF6-AC5F-9EF30BCC5721}"/>
                  </a:ext>
                </a:extLst>
              </p:cNvPr>
              <p:cNvSpPr txBox="1"/>
              <p:nvPr/>
            </p:nvSpPr>
            <p:spPr>
              <a:xfrm rot="16200000">
                <a:off x="2461745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control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="" xmlns:a16="http://schemas.microsoft.com/office/drawing/2014/main" id="{CA763229-5A22-4F20-8CDF-1C12390FFB49}"/>
                  </a:ext>
                </a:extLst>
              </p:cNvPr>
              <p:cNvSpPr txBox="1"/>
              <p:nvPr/>
            </p:nvSpPr>
            <p:spPr>
              <a:xfrm rot="16200000">
                <a:off x="2287888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="" xmlns:a16="http://schemas.microsoft.com/office/drawing/2014/main" id="{507B0FA4-D37B-4A80-A43C-120DA38D9E5A}"/>
                  </a:ext>
                </a:extLst>
              </p:cNvPr>
              <p:cNvSpPr txBox="1"/>
              <p:nvPr/>
            </p:nvSpPr>
            <p:spPr>
              <a:xfrm rot="16200000">
                <a:off x="3157171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iR-486-5p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="" xmlns:a16="http://schemas.microsoft.com/office/drawing/2014/main" id="{3C4D735D-D718-4E68-889F-370CE49F7458}"/>
                  </a:ext>
                </a:extLst>
              </p:cNvPr>
              <p:cNvSpPr txBox="1"/>
              <p:nvPr/>
            </p:nvSpPr>
            <p:spPr>
              <a:xfrm rot="16200000">
                <a:off x="2983316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control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="" xmlns:a16="http://schemas.microsoft.com/office/drawing/2014/main" id="{CA940028-8535-4834-9D54-E627F7357225}"/>
                  </a:ext>
                </a:extLst>
              </p:cNvPr>
              <p:cNvSpPr txBox="1"/>
              <p:nvPr/>
            </p:nvSpPr>
            <p:spPr>
              <a:xfrm rot="16200000">
                <a:off x="2809459" y="2934794"/>
                <a:ext cx="86989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4" name="テキスト ボックス 43">
              <a:extLst>
                <a:ext uri="{FF2B5EF4-FFF2-40B4-BE49-F238E27FC236}">
                  <a16:creationId xmlns="" xmlns:a16="http://schemas.microsoft.com/office/drawing/2014/main" id="{957429D2-CECE-417D-9380-1EE322FA3AA1}"/>
                </a:ext>
              </a:extLst>
            </p:cNvPr>
            <p:cNvSpPr txBox="1"/>
            <p:nvPr/>
          </p:nvSpPr>
          <p:spPr>
            <a:xfrm>
              <a:off x="2492920" y="712676"/>
              <a:ext cx="7220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DP-R-</a:t>
              </a:r>
            </a:p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OY</a:t>
              </a:r>
              <a:endParaRPr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直線コネクタ 44">
              <a:extLst>
                <a:ext uri="{FF2B5EF4-FFF2-40B4-BE49-F238E27FC236}">
                  <a16:creationId xmlns="" xmlns:a16="http://schemas.microsoft.com/office/drawing/2014/main" id="{2630B1C3-2388-43E3-97FF-4E6A0E285B88}"/>
                </a:ext>
              </a:extLst>
            </p:cNvPr>
            <p:cNvCxnSpPr>
              <a:cxnSpLocks/>
            </p:cNvCxnSpPr>
            <p:nvPr/>
          </p:nvCxnSpPr>
          <p:spPr>
            <a:xfrm>
              <a:off x="2619941" y="1116037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="" xmlns:a16="http://schemas.microsoft.com/office/drawing/2014/main" id="{8AE4DCC0-5C70-4A05-8B0D-2495D0DF0ED0}"/>
                </a:ext>
              </a:extLst>
            </p:cNvPr>
            <p:cNvCxnSpPr>
              <a:cxnSpLocks/>
            </p:cNvCxnSpPr>
            <p:nvPr/>
          </p:nvCxnSpPr>
          <p:spPr>
            <a:xfrm>
              <a:off x="3190686" y="1116037"/>
              <a:ext cx="4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テキスト ボックス 46">
              <a:extLst>
                <a:ext uri="{FF2B5EF4-FFF2-40B4-BE49-F238E27FC236}">
                  <a16:creationId xmlns="" xmlns:a16="http://schemas.microsoft.com/office/drawing/2014/main" id="{178EE37C-115B-4AEF-9C5B-F7F2B57CF0AF}"/>
                </a:ext>
              </a:extLst>
            </p:cNvPr>
            <p:cNvSpPr txBox="1"/>
            <p:nvPr/>
          </p:nvSpPr>
          <p:spPr>
            <a:xfrm>
              <a:off x="3063665" y="715950"/>
              <a:ext cx="72204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DP-R-</a:t>
              </a:r>
            </a:p>
            <a:p>
              <a:pPr algn="ctr"/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24</a:t>
              </a:r>
              <a:endParaRPr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574017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テキスト ボックス 24">
            <a:extLst>
              <a:ext uri="{FF2B5EF4-FFF2-40B4-BE49-F238E27FC236}">
                <a16:creationId xmlns="" xmlns:a16="http://schemas.microsoft.com/office/drawing/2014/main" id="{9C5AD8FD-0783-46CF-A64E-DB86EFDAE8DD}"/>
              </a:ext>
            </a:extLst>
          </p:cNvPr>
          <p:cNvSpPr txBox="1"/>
          <p:nvPr/>
        </p:nvSpPr>
        <p:spPr>
          <a:xfrm>
            <a:off x="230697" y="227692"/>
            <a:ext cx="18102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r>
              <a:rPr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図 45" descr="写真, ホワイト, 座る, 大きい が含まれている画像&#10;&#10;自動的に生成された説明">
            <a:extLst>
              <a:ext uri="{FF2B5EF4-FFF2-40B4-BE49-F238E27FC236}">
                <a16:creationId xmlns="" xmlns:a16="http://schemas.microsoft.com/office/drawing/2014/main" id="{E3F5D378-A8FD-40BB-8A0D-1EEA737EF49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74" t="28682" r="26498" b="26743"/>
          <a:stretch/>
        </p:blipFill>
        <p:spPr>
          <a:xfrm>
            <a:off x="1038687" y="2016914"/>
            <a:ext cx="2902998" cy="28746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図 46" descr="屋内, 探す, ホワイト, 冷蔵庫 が含まれている画像&#10;&#10;自動的に生成された説明">
            <a:extLst>
              <a:ext uri="{FF2B5EF4-FFF2-40B4-BE49-F238E27FC236}">
                <a16:creationId xmlns="" xmlns:a16="http://schemas.microsoft.com/office/drawing/2014/main" id="{146FC37B-637A-455D-9EE0-472A8C85190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31" t="29319" r="27362" b="26296"/>
          <a:stretch/>
        </p:blipFill>
        <p:spPr>
          <a:xfrm>
            <a:off x="4653645" y="2013818"/>
            <a:ext cx="2902998" cy="28689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正方形/長方形 47">
            <a:extLst>
              <a:ext uri="{FF2B5EF4-FFF2-40B4-BE49-F238E27FC236}">
                <a16:creationId xmlns="" xmlns:a16="http://schemas.microsoft.com/office/drawing/2014/main" id="{D84B72A5-4690-4030-BFB4-5D3119DA662E}"/>
              </a:ext>
            </a:extLst>
          </p:cNvPr>
          <p:cNvSpPr/>
          <p:nvPr/>
        </p:nvSpPr>
        <p:spPr>
          <a:xfrm>
            <a:off x="2920751" y="3355759"/>
            <a:ext cx="746095" cy="2523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テキスト ボックス 48">
            <a:extLst>
              <a:ext uri="{FF2B5EF4-FFF2-40B4-BE49-F238E27FC236}">
                <a16:creationId xmlns="" xmlns:a16="http://schemas.microsoft.com/office/drawing/2014/main" id="{7DA517FA-737F-4009-A40A-5F7E0BAC6E14}"/>
              </a:ext>
            </a:extLst>
          </p:cNvPr>
          <p:cNvSpPr txBox="1"/>
          <p:nvPr/>
        </p:nvSpPr>
        <p:spPr>
          <a:xfrm>
            <a:off x="8123908" y="3286648"/>
            <a:ext cx="951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="" xmlns:a16="http://schemas.microsoft.com/office/drawing/2014/main" id="{5914BD01-C7E2-46E4-9ABE-316420D9F0A2}"/>
              </a:ext>
            </a:extLst>
          </p:cNvPr>
          <p:cNvSpPr txBox="1"/>
          <p:nvPr/>
        </p:nvSpPr>
        <p:spPr>
          <a:xfrm>
            <a:off x="7577358" y="3286648"/>
            <a:ext cx="75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="" xmlns:a16="http://schemas.microsoft.com/office/drawing/2014/main" id="{5C88E71C-5FCB-40E7-8AAF-3821F5619826}"/>
              </a:ext>
            </a:extLst>
          </p:cNvPr>
          <p:cNvSpPr txBox="1"/>
          <p:nvPr/>
        </p:nvSpPr>
        <p:spPr>
          <a:xfrm>
            <a:off x="8144368" y="2855310"/>
            <a:ext cx="988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HHADH</a:t>
            </a:r>
            <a:endParaRPr lang="ja-JP" altLang="en-US" sz="1200" b="1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="" xmlns:a16="http://schemas.microsoft.com/office/drawing/2014/main" id="{14DF1360-822C-450B-B339-A336F56402D9}"/>
              </a:ext>
            </a:extLst>
          </p:cNvPr>
          <p:cNvSpPr txBox="1"/>
          <p:nvPr/>
        </p:nvSpPr>
        <p:spPr>
          <a:xfrm>
            <a:off x="7578830" y="2855310"/>
            <a:ext cx="751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9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="" xmlns:a16="http://schemas.microsoft.com/office/drawing/2014/main" id="{0A1AA029-9BEA-45E7-A28A-FBB04BB93E81}"/>
              </a:ext>
            </a:extLst>
          </p:cNvPr>
          <p:cNvSpPr txBox="1"/>
          <p:nvPr/>
        </p:nvSpPr>
        <p:spPr>
          <a:xfrm>
            <a:off x="958182" y="4882720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5sec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="" xmlns:a16="http://schemas.microsoft.com/office/drawing/2014/main" id="{9D19C2B3-50FD-4785-8EBA-B927F80F90AF}"/>
              </a:ext>
            </a:extLst>
          </p:cNvPr>
          <p:cNvSpPr txBox="1"/>
          <p:nvPr/>
        </p:nvSpPr>
        <p:spPr>
          <a:xfrm>
            <a:off x="4564322" y="4902376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1m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="" xmlns:a16="http://schemas.microsoft.com/office/drawing/2014/main" id="{4F8E8882-9F33-43DC-8882-448D371A5A25}"/>
              </a:ext>
            </a:extLst>
          </p:cNvPr>
          <p:cNvSpPr/>
          <p:nvPr/>
        </p:nvSpPr>
        <p:spPr>
          <a:xfrm>
            <a:off x="6556169" y="2873066"/>
            <a:ext cx="732396" cy="2274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7" name="グループ化 56">
            <a:extLst>
              <a:ext uri="{FF2B5EF4-FFF2-40B4-BE49-F238E27FC236}">
                <a16:creationId xmlns="" xmlns:a16="http://schemas.microsoft.com/office/drawing/2014/main" id="{DFD06599-EA12-4915-812B-60DA500AC84C}"/>
              </a:ext>
            </a:extLst>
          </p:cNvPr>
          <p:cNvGrpSpPr/>
          <p:nvPr/>
        </p:nvGrpSpPr>
        <p:grpSpPr>
          <a:xfrm>
            <a:off x="2887728" y="1003176"/>
            <a:ext cx="799601" cy="1010642"/>
            <a:chOff x="2606801" y="2482210"/>
            <a:chExt cx="753639" cy="1010642"/>
          </a:xfrm>
        </p:grpSpPr>
        <p:sp>
          <p:nvSpPr>
            <p:cNvPr id="62" name="テキスト ボックス 61">
              <a:extLst>
                <a:ext uri="{FF2B5EF4-FFF2-40B4-BE49-F238E27FC236}">
                  <a16:creationId xmlns="" xmlns:a16="http://schemas.microsoft.com/office/drawing/2014/main" id="{8B417E26-05EC-49F7-AF64-63E1264DDAB8}"/>
                </a:ext>
              </a:extLst>
            </p:cNvPr>
            <p:cNvSpPr txBox="1"/>
            <p:nvPr/>
          </p:nvSpPr>
          <p:spPr>
            <a:xfrm rot="16200000">
              <a:off x="2635602" y="2941871"/>
              <a:ext cx="869894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2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="" xmlns:a16="http://schemas.microsoft.com/office/drawing/2014/main" id="{12155861-9F0C-4C97-A38A-16FAB6B05E72}"/>
                </a:ext>
              </a:extLst>
            </p:cNvPr>
            <p:cNvSpPr txBox="1"/>
            <p:nvPr/>
          </p:nvSpPr>
          <p:spPr>
            <a:xfrm rot="16200000">
              <a:off x="2391371" y="2871497"/>
              <a:ext cx="1010642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DDP-R-BO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="" xmlns:a16="http://schemas.microsoft.com/office/drawing/2014/main" id="{A999830B-A7B7-4BBE-8291-17C10D552508}"/>
                </a:ext>
              </a:extLst>
            </p:cNvPr>
            <p:cNvSpPr txBox="1"/>
            <p:nvPr/>
          </p:nvSpPr>
          <p:spPr>
            <a:xfrm rot="16200000">
              <a:off x="2217515" y="2871497"/>
              <a:ext cx="1010639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O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="" xmlns:a16="http://schemas.microsoft.com/office/drawing/2014/main" id="{2550575F-F94A-4BE4-8CB5-531ED15C0906}"/>
                </a:ext>
              </a:extLst>
            </p:cNvPr>
            <p:cNvSpPr txBox="1"/>
            <p:nvPr/>
          </p:nvSpPr>
          <p:spPr>
            <a:xfrm rot="16200000">
              <a:off x="2809459" y="2941871"/>
              <a:ext cx="869894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DDP-T2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グループ化 79">
            <a:extLst>
              <a:ext uri="{FF2B5EF4-FFF2-40B4-BE49-F238E27FC236}">
                <a16:creationId xmlns="" xmlns:a16="http://schemas.microsoft.com/office/drawing/2014/main" id="{BB3B48F4-CC91-441B-B16C-0D5B45EADECB}"/>
              </a:ext>
            </a:extLst>
          </p:cNvPr>
          <p:cNvGrpSpPr/>
          <p:nvPr/>
        </p:nvGrpSpPr>
        <p:grpSpPr>
          <a:xfrm>
            <a:off x="6551110" y="1022406"/>
            <a:ext cx="799601" cy="1010642"/>
            <a:chOff x="2606801" y="2482210"/>
            <a:chExt cx="753639" cy="1010642"/>
          </a:xfrm>
        </p:grpSpPr>
        <p:sp>
          <p:nvSpPr>
            <p:cNvPr id="81" name="テキスト ボックス 80">
              <a:extLst>
                <a:ext uri="{FF2B5EF4-FFF2-40B4-BE49-F238E27FC236}">
                  <a16:creationId xmlns="" xmlns:a16="http://schemas.microsoft.com/office/drawing/2014/main" id="{09B6B3C8-3D1F-4F94-B26C-06D624D8A0D4}"/>
                </a:ext>
              </a:extLst>
            </p:cNvPr>
            <p:cNvSpPr txBox="1"/>
            <p:nvPr/>
          </p:nvSpPr>
          <p:spPr>
            <a:xfrm rot="16200000">
              <a:off x="2635602" y="2941871"/>
              <a:ext cx="869894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T2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="" xmlns:a16="http://schemas.microsoft.com/office/drawing/2014/main" id="{532EBC1B-D992-4631-9347-5691981211FC}"/>
                </a:ext>
              </a:extLst>
            </p:cNvPr>
            <p:cNvSpPr txBox="1"/>
            <p:nvPr/>
          </p:nvSpPr>
          <p:spPr>
            <a:xfrm rot="16200000">
              <a:off x="2391371" y="2871497"/>
              <a:ext cx="1010642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DDP-R-BO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="" xmlns:a16="http://schemas.microsoft.com/office/drawing/2014/main" id="{12F17660-C723-4728-9A00-3354ECC4E5DB}"/>
                </a:ext>
              </a:extLst>
            </p:cNvPr>
            <p:cNvSpPr txBox="1"/>
            <p:nvPr/>
          </p:nvSpPr>
          <p:spPr>
            <a:xfrm rot="16200000">
              <a:off x="2217515" y="2871497"/>
              <a:ext cx="1010639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OY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="" xmlns:a16="http://schemas.microsoft.com/office/drawing/2014/main" id="{8585E2FC-7A9B-4F26-8CF8-6DCB31B44A86}"/>
                </a:ext>
              </a:extLst>
            </p:cNvPr>
            <p:cNvSpPr txBox="1"/>
            <p:nvPr/>
          </p:nvSpPr>
          <p:spPr>
            <a:xfrm rot="16200000">
              <a:off x="2809459" y="2941871"/>
              <a:ext cx="869894" cy="232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DDP-T2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177169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="" xmlns:a16="http://schemas.microsoft.com/office/drawing/2014/main" id="{3238CD49-5D25-47E1-847B-DF626C594444}"/>
              </a:ext>
            </a:extLst>
          </p:cNvPr>
          <p:cNvSpPr txBox="1"/>
          <p:nvPr/>
        </p:nvSpPr>
        <p:spPr>
          <a:xfrm>
            <a:off x="240923" y="228700"/>
            <a:ext cx="17599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6B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="" xmlns:a16="http://schemas.microsoft.com/office/drawing/2014/main" id="{53F9BA45-FF5C-4C06-8FEE-BBAB6A9E37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890" t="24321" r="27779" b="31724"/>
          <a:stretch/>
        </p:blipFill>
        <p:spPr>
          <a:xfrm>
            <a:off x="6122259" y="2004508"/>
            <a:ext cx="2511303" cy="24934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="" xmlns:a16="http://schemas.microsoft.com/office/drawing/2014/main" id="{37F82343-ADAE-44B0-BD09-BA9EE5610C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267" t="23915" r="27575" b="31301"/>
          <a:stretch/>
        </p:blipFill>
        <p:spPr>
          <a:xfrm>
            <a:off x="8691264" y="2004508"/>
            <a:ext cx="2452409" cy="24890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="" xmlns:a16="http://schemas.microsoft.com/office/drawing/2014/main" id="{CF130073-1D46-4F35-92F7-06B444E461D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459" t="32935" r="25544" b="23463"/>
          <a:stretch/>
        </p:blipFill>
        <p:spPr>
          <a:xfrm>
            <a:off x="2607692" y="2015838"/>
            <a:ext cx="2511303" cy="24890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>
            <a:extLst>
              <a:ext uri="{FF2B5EF4-FFF2-40B4-BE49-F238E27FC236}">
                <a16:creationId xmlns="" xmlns:a16="http://schemas.microsoft.com/office/drawing/2014/main" id="{3C7284F7-59DC-4792-826B-1A16DBC0A85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0368" t="33132" r="26205" b="22557"/>
          <a:stretch/>
        </p:blipFill>
        <p:spPr>
          <a:xfrm>
            <a:off x="68085" y="2014560"/>
            <a:ext cx="2491150" cy="24890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テキスト ボックス 12">
            <a:extLst>
              <a:ext uri="{FF2B5EF4-FFF2-40B4-BE49-F238E27FC236}">
                <a16:creationId xmlns="" xmlns:a16="http://schemas.microsoft.com/office/drawing/2014/main" id="{62875A7B-A11D-4C5D-B272-EF6C206C1493}"/>
              </a:ext>
            </a:extLst>
          </p:cNvPr>
          <p:cNvSpPr txBox="1"/>
          <p:nvPr/>
        </p:nvSpPr>
        <p:spPr>
          <a:xfrm>
            <a:off x="11110076" y="3074780"/>
            <a:ext cx="70676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ja-JP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="" xmlns:a16="http://schemas.microsoft.com/office/drawing/2014/main" id="{5673DEC7-3544-4FBD-89DF-A2A44EA8345A}"/>
              </a:ext>
            </a:extLst>
          </p:cNvPr>
          <p:cNvSpPr txBox="1"/>
          <p:nvPr/>
        </p:nvSpPr>
        <p:spPr>
          <a:xfrm>
            <a:off x="10634550" y="3074780"/>
            <a:ext cx="55811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  <a:endParaRPr lang="ja-JP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="" xmlns:a16="http://schemas.microsoft.com/office/drawing/2014/main" id="{20C75FFC-42D1-41E8-812E-7F6676FF086C}"/>
              </a:ext>
            </a:extLst>
          </p:cNvPr>
          <p:cNvSpPr txBox="1"/>
          <p:nvPr/>
        </p:nvSpPr>
        <p:spPr>
          <a:xfrm>
            <a:off x="11130536" y="2698568"/>
            <a:ext cx="734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0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HHADH</a:t>
            </a:r>
            <a:endParaRPr lang="ja-JP" altLang="en-US" sz="1000" b="1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="" xmlns:a16="http://schemas.microsoft.com/office/drawing/2014/main" id="{B5651688-9260-4372-8C8E-96DD069B83E6}"/>
              </a:ext>
            </a:extLst>
          </p:cNvPr>
          <p:cNvSpPr txBox="1"/>
          <p:nvPr/>
        </p:nvSpPr>
        <p:spPr>
          <a:xfrm>
            <a:off x="10636022" y="2698568"/>
            <a:ext cx="55811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lvl="0" algn="r"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9kDa</a:t>
            </a:r>
            <a:endParaRPr lang="ja-JP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="" xmlns:a16="http://schemas.microsoft.com/office/drawing/2014/main" id="{48F1219D-E0D9-43E2-9505-90509BD780F9}"/>
              </a:ext>
            </a:extLst>
          </p:cNvPr>
          <p:cNvSpPr/>
          <p:nvPr/>
        </p:nvSpPr>
        <p:spPr>
          <a:xfrm>
            <a:off x="551725" y="3213902"/>
            <a:ext cx="596701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="" xmlns:a16="http://schemas.microsoft.com/office/drawing/2014/main" id="{130D5532-25E2-4A86-87CC-699B92E8A8CC}"/>
              </a:ext>
            </a:extLst>
          </p:cNvPr>
          <p:cNvSpPr txBox="1"/>
          <p:nvPr/>
        </p:nvSpPr>
        <p:spPr>
          <a:xfrm>
            <a:off x="5094526" y="3286599"/>
            <a:ext cx="70676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ja-JP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="" xmlns:a16="http://schemas.microsoft.com/office/drawing/2014/main" id="{979DD5DB-729D-4F93-9C0F-90C9F3B55CA1}"/>
              </a:ext>
            </a:extLst>
          </p:cNvPr>
          <p:cNvSpPr txBox="1"/>
          <p:nvPr/>
        </p:nvSpPr>
        <p:spPr>
          <a:xfrm>
            <a:off x="4619000" y="3286599"/>
            <a:ext cx="55811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  <a:endParaRPr lang="ja-JP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="" xmlns:a16="http://schemas.microsoft.com/office/drawing/2014/main" id="{3DB181D1-B61F-464C-9257-EEE4460F3394}"/>
              </a:ext>
            </a:extLst>
          </p:cNvPr>
          <p:cNvSpPr txBox="1"/>
          <p:nvPr/>
        </p:nvSpPr>
        <p:spPr>
          <a:xfrm>
            <a:off x="5114986" y="2860145"/>
            <a:ext cx="7340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0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HHADH</a:t>
            </a:r>
            <a:endParaRPr lang="ja-JP" altLang="en-US" sz="1000" b="1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="" xmlns:a16="http://schemas.microsoft.com/office/drawing/2014/main" id="{A41BB99C-3D10-4B0B-8794-F16105244CE4}"/>
              </a:ext>
            </a:extLst>
          </p:cNvPr>
          <p:cNvSpPr txBox="1"/>
          <p:nvPr/>
        </p:nvSpPr>
        <p:spPr>
          <a:xfrm>
            <a:off x="4620472" y="2848571"/>
            <a:ext cx="55811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lvl="0" algn="r">
              <a:defRPr/>
            </a:pPr>
            <a:r>
              <a:rPr lang="en-US" altLang="ja-JP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9kDa</a:t>
            </a:r>
            <a:endParaRPr lang="ja-JP" altLang="en-US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="" xmlns:a16="http://schemas.microsoft.com/office/drawing/2014/main" id="{DDA06F59-0EC1-4B4E-9D4D-527841C7DF07}"/>
              </a:ext>
            </a:extLst>
          </p:cNvPr>
          <p:cNvSpPr txBox="1"/>
          <p:nvPr/>
        </p:nvSpPr>
        <p:spPr>
          <a:xfrm>
            <a:off x="2501070" y="4493585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1m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5E0470CE-8141-4EDE-958D-035E053C9427}"/>
              </a:ext>
            </a:extLst>
          </p:cNvPr>
          <p:cNvSpPr txBox="1"/>
          <p:nvPr/>
        </p:nvSpPr>
        <p:spPr>
          <a:xfrm>
            <a:off x="8611215" y="4493583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2m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="" xmlns:a16="http://schemas.microsoft.com/office/drawing/2014/main" id="{22961C91-B814-4B5F-98DC-958BB92586FA}"/>
              </a:ext>
            </a:extLst>
          </p:cNvPr>
          <p:cNvSpPr txBox="1"/>
          <p:nvPr/>
        </p:nvSpPr>
        <p:spPr>
          <a:xfrm>
            <a:off x="-43549" y="4493586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5sec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="" xmlns:a16="http://schemas.microsoft.com/office/drawing/2014/main" id="{B2DD82F8-0E76-4546-B011-8851EFCAB1E2}"/>
              </a:ext>
            </a:extLst>
          </p:cNvPr>
          <p:cNvSpPr txBox="1"/>
          <p:nvPr/>
        </p:nvSpPr>
        <p:spPr>
          <a:xfrm>
            <a:off x="6005835" y="4493584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5sec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正方形/長方形 68">
            <a:extLst>
              <a:ext uri="{FF2B5EF4-FFF2-40B4-BE49-F238E27FC236}">
                <a16:creationId xmlns="" xmlns:a16="http://schemas.microsoft.com/office/drawing/2014/main" id="{4ACE377E-05C6-4C04-8262-4B87D8D80376}"/>
              </a:ext>
            </a:extLst>
          </p:cNvPr>
          <p:cNvSpPr/>
          <p:nvPr/>
        </p:nvSpPr>
        <p:spPr>
          <a:xfrm>
            <a:off x="1148426" y="3213902"/>
            <a:ext cx="638912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1" name="正方形/長方形 70">
            <a:extLst>
              <a:ext uri="{FF2B5EF4-FFF2-40B4-BE49-F238E27FC236}">
                <a16:creationId xmlns="" xmlns:a16="http://schemas.microsoft.com/office/drawing/2014/main" id="{844F59AF-0BA8-43CB-9AF1-29FA6032D03B}"/>
              </a:ext>
            </a:extLst>
          </p:cNvPr>
          <p:cNvSpPr/>
          <p:nvPr/>
        </p:nvSpPr>
        <p:spPr>
          <a:xfrm>
            <a:off x="3053749" y="2853136"/>
            <a:ext cx="622521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3" name="正方形/長方形 72">
            <a:extLst>
              <a:ext uri="{FF2B5EF4-FFF2-40B4-BE49-F238E27FC236}">
                <a16:creationId xmlns="" xmlns:a16="http://schemas.microsoft.com/office/drawing/2014/main" id="{867B7EF4-E9F5-403E-A735-2B6C6EA09385}"/>
              </a:ext>
            </a:extLst>
          </p:cNvPr>
          <p:cNvSpPr/>
          <p:nvPr/>
        </p:nvSpPr>
        <p:spPr>
          <a:xfrm>
            <a:off x="3676270" y="2853136"/>
            <a:ext cx="638912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5" name="正方形/長方形 74">
            <a:extLst>
              <a:ext uri="{FF2B5EF4-FFF2-40B4-BE49-F238E27FC236}">
                <a16:creationId xmlns="" xmlns:a16="http://schemas.microsoft.com/office/drawing/2014/main" id="{A0F969C3-AEFE-4315-953D-A415D6B9CD34}"/>
              </a:ext>
            </a:extLst>
          </p:cNvPr>
          <p:cNvSpPr/>
          <p:nvPr/>
        </p:nvSpPr>
        <p:spPr>
          <a:xfrm>
            <a:off x="6597483" y="3086354"/>
            <a:ext cx="622521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7" name="正方形/長方形 76">
            <a:extLst>
              <a:ext uri="{FF2B5EF4-FFF2-40B4-BE49-F238E27FC236}">
                <a16:creationId xmlns="" xmlns:a16="http://schemas.microsoft.com/office/drawing/2014/main" id="{FE66B677-3DB4-4B58-ABA8-070A5D316517}"/>
              </a:ext>
            </a:extLst>
          </p:cNvPr>
          <p:cNvSpPr/>
          <p:nvPr/>
        </p:nvSpPr>
        <p:spPr>
          <a:xfrm>
            <a:off x="7220004" y="3086354"/>
            <a:ext cx="638912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9" name="正方形/長方形 78">
            <a:extLst>
              <a:ext uri="{FF2B5EF4-FFF2-40B4-BE49-F238E27FC236}">
                <a16:creationId xmlns="" xmlns:a16="http://schemas.microsoft.com/office/drawing/2014/main" id="{40168E4F-DCF9-4CC7-8FD8-62E2CAC90BB1}"/>
              </a:ext>
            </a:extLst>
          </p:cNvPr>
          <p:cNvSpPr/>
          <p:nvPr/>
        </p:nvSpPr>
        <p:spPr>
          <a:xfrm>
            <a:off x="9149697" y="2705577"/>
            <a:ext cx="622521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81" name="正方形/長方形 80">
            <a:extLst>
              <a:ext uri="{FF2B5EF4-FFF2-40B4-BE49-F238E27FC236}">
                <a16:creationId xmlns="" xmlns:a16="http://schemas.microsoft.com/office/drawing/2014/main" id="{BBDAE6F5-4A28-4BEC-A71A-914310FFDAC2}"/>
              </a:ext>
            </a:extLst>
          </p:cNvPr>
          <p:cNvSpPr/>
          <p:nvPr/>
        </p:nvSpPr>
        <p:spPr>
          <a:xfrm>
            <a:off x="9772218" y="2705577"/>
            <a:ext cx="638912" cy="2266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E0E37EDA-DFFF-4280-9963-33A2401AD22E}"/>
              </a:ext>
            </a:extLst>
          </p:cNvPr>
          <p:cNvSpPr txBox="1"/>
          <p:nvPr/>
        </p:nvSpPr>
        <p:spPr>
          <a:xfrm>
            <a:off x="6485064" y="675688"/>
            <a:ext cx="8049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="" xmlns:a16="http://schemas.microsoft.com/office/drawing/2014/main" id="{C55E8BF3-D7F3-4FA4-A8A3-E5A68A6ACCE0}"/>
              </a:ext>
            </a:extLst>
          </p:cNvPr>
          <p:cNvCxnSpPr>
            <a:cxnSpLocks/>
          </p:cNvCxnSpPr>
          <p:nvPr/>
        </p:nvCxnSpPr>
        <p:spPr>
          <a:xfrm>
            <a:off x="6599519" y="1075798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4" name="グループ化 103">
            <a:extLst>
              <a:ext uri="{FF2B5EF4-FFF2-40B4-BE49-F238E27FC236}">
                <a16:creationId xmlns="" xmlns:a16="http://schemas.microsoft.com/office/drawing/2014/main" id="{8A707156-A5CC-40D2-8F58-B1F27E2BBEDA}"/>
              </a:ext>
            </a:extLst>
          </p:cNvPr>
          <p:cNvGrpSpPr/>
          <p:nvPr/>
        </p:nvGrpSpPr>
        <p:grpSpPr>
          <a:xfrm>
            <a:off x="6530232" y="987657"/>
            <a:ext cx="1314871" cy="1015405"/>
            <a:chOff x="5113613" y="997175"/>
            <a:chExt cx="1549404" cy="1015405"/>
          </a:xfrm>
        </p:grpSpPr>
        <p:sp>
          <p:nvSpPr>
            <p:cNvPr id="82" name="テキスト ボックス 81">
              <a:extLst>
                <a:ext uri="{FF2B5EF4-FFF2-40B4-BE49-F238E27FC236}">
                  <a16:creationId xmlns="" xmlns:a16="http://schemas.microsoft.com/office/drawing/2014/main" id="{752A3B21-E390-44E2-A6D0-79E32D614E9E}"/>
                </a:ext>
              </a:extLst>
            </p:cNvPr>
            <p:cNvSpPr txBox="1"/>
            <p:nvPr/>
          </p:nvSpPr>
          <p:spPr>
            <a:xfrm rot="16200000">
              <a:off x="5106277" y="1380941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="" xmlns:a16="http://schemas.microsoft.com/office/drawing/2014/main" id="{0104B945-3314-4372-9B29-002401FCE346}"/>
                </a:ext>
              </a:extLst>
            </p:cNvPr>
            <p:cNvSpPr txBox="1"/>
            <p:nvPr/>
          </p:nvSpPr>
          <p:spPr>
            <a:xfrm rot="16200000">
              <a:off x="4993745" y="1452869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="" xmlns:a16="http://schemas.microsoft.com/office/drawing/2014/main" id="{DD2EEE29-75DA-45B3-9684-9763EDBD1769}"/>
                </a:ext>
              </a:extLst>
            </p:cNvPr>
            <p:cNvSpPr txBox="1"/>
            <p:nvPr/>
          </p:nvSpPr>
          <p:spPr>
            <a:xfrm rot="16200000">
              <a:off x="4809285" y="1445361"/>
              <a:ext cx="869894" cy="261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="" xmlns:a16="http://schemas.microsoft.com/office/drawing/2014/main" id="{69332A08-F997-449E-890D-DB9679C612DD}"/>
                </a:ext>
              </a:extLst>
            </p:cNvPr>
            <p:cNvSpPr txBox="1"/>
            <p:nvPr/>
          </p:nvSpPr>
          <p:spPr>
            <a:xfrm rot="16200000">
              <a:off x="5290737" y="1380940"/>
              <a:ext cx="1013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="" xmlns:a16="http://schemas.microsoft.com/office/drawing/2014/main" id="{9F2B7ED0-89B1-4DAC-8286-AA08AD225600}"/>
                </a:ext>
              </a:extLst>
            </p:cNvPr>
            <p:cNvSpPr txBox="1"/>
            <p:nvPr/>
          </p:nvSpPr>
          <p:spPr>
            <a:xfrm rot="16200000">
              <a:off x="5848571" y="1382594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="" xmlns:a16="http://schemas.microsoft.com/office/drawing/2014/main" id="{CA53DE07-A266-47B3-8E0C-AA385F8FE6EC}"/>
                </a:ext>
              </a:extLst>
            </p:cNvPr>
            <p:cNvSpPr txBox="1"/>
            <p:nvPr/>
          </p:nvSpPr>
          <p:spPr>
            <a:xfrm rot="16200000">
              <a:off x="5736038" y="1454522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="" xmlns:a16="http://schemas.microsoft.com/office/drawing/2014/main" id="{35C0DED4-486B-4898-9D38-D6EF5514A2C7}"/>
                </a:ext>
              </a:extLst>
            </p:cNvPr>
            <p:cNvSpPr txBox="1"/>
            <p:nvPr/>
          </p:nvSpPr>
          <p:spPr>
            <a:xfrm rot="16200000">
              <a:off x="5569763" y="1447014"/>
              <a:ext cx="869894" cy="261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="" xmlns:a16="http://schemas.microsoft.com/office/drawing/2014/main" id="{302F7AD7-E6DD-4EB2-AE9F-9495694C87B2}"/>
                </a:ext>
              </a:extLst>
            </p:cNvPr>
            <p:cNvSpPr txBox="1"/>
            <p:nvPr/>
          </p:nvSpPr>
          <p:spPr>
            <a:xfrm rot="16200000">
              <a:off x="6033031" y="1382593"/>
              <a:ext cx="1013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</p:grpSp>
      <p:sp>
        <p:nvSpPr>
          <p:cNvPr id="92" name="テキスト ボックス 91">
            <a:extLst>
              <a:ext uri="{FF2B5EF4-FFF2-40B4-BE49-F238E27FC236}">
                <a16:creationId xmlns="" xmlns:a16="http://schemas.microsoft.com/office/drawing/2014/main" id="{6E0B500B-CEEC-4AA2-876F-2A1C8E051773}"/>
              </a:ext>
            </a:extLst>
          </p:cNvPr>
          <p:cNvSpPr txBox="1"/>
          <p:nvPr/>
        </p:nvSpPr>
        <p:spPr>
          <a:xfrm>
            <a:off x="7133655" y="669623"/>
            <a:ext cx="8049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線コネクタ 92">
            <a:extLst>
              <a:ext uri="{FF2B5EF4-FFF2-40B4-BE49-F238E27FC236}">
                <a16:creationId xmlns="" xmlns:a16="http://schemas.microsoft.com/office/drawing/2014/main" id="{7F3AF13E-656E-492C-8E9C-AFE7B3156660}"/>
              </a:ext>
            </a:extLst>
          </p:cNvPr>
          <p:cNvCxnSpPr>
            <a:cxnSpLocks/>
          </p:cNvCxnSpPr>
          <p:nvPr/>
        </p:nvCxnSpPr>
        <p:spPr>
          <a:xfrm>
            <a:off x="7248110" y="1072984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>
            <a:extLst>
              <a:ext uri="{FF2B5EF4-FFF2-40B4-BE49-F238E27FC236}">
                <a16:creationId xmlns="" xmlns:a16="http://schemas.microsoft.com/office/drawing/2014/main" id="{F97DF45E-FA24-471D-9E79-468E04699EA8}"/>
              </a:ext>
            </a:extLst>
          </p:cNvPr>
          <p:cNvSpPr txBox="1"/>
          <p:nvPr/>
        </p:nvSpPr>
        <p:spPr>
          <a:xfrm>
            <a:off x="9046522" y="662461"/>
            <a:ext cx="8049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線コネクタ 105">
            <a:extLst>
              <a:ext uri="{FF2B5EF4-FFF2-40B4-BE49-F238E27FC236}">
                <a16:creationId xmlns="" xmlns:a16="http://schemas.microsoft.com/office/drawing/2014/main" id="{A4746ACF-2E4E-432B-9613-E85F83EA3EED}"/>
              </a:ext>
            </a:extLst>
          </p:cNvPr>
          <p:cNvCxnSpPr>
            <a:cxnSpLocks/>
          </p:cNvCxnSpPr>
          <p:nvPr/>
        </p:nvCxnSpPr>
        <p:spPr>
          <a:xfrm>
            <a:off x="9160977" y="1062571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7" name="グループ化 106">
            <a:extLst>
              <a:ext uri="{FF2B5EF4-FFF2-40B4-BE49-F238E27FC236}">
                <a16:creationId xmlns="" xmlns:a16="http://schemas.microsoft.com/office/drawing/2014/main" id="{DC41C610-9CA2-46F5-ACCD-3840F46AFA37}"/>
              </a:ext>
            </a:extLst>
          </p:cNvPr>
          <p:cNvGrpSpPr/>
          <p:nvPr/>
        </p:nvGrpSpPr>
        <p:grpSpPr>
          <a:xfrm>
            <a:off x="9122542" y="974430"/>
            <a:ext cx="1256999" cy="1015405"/>
            <a:chOff x="5149981" y="997175"/>
            <a:chExt cx="1481212" cy="1015405"/>
          </a:xfrm>
        </p:grpSpPr>
        <p:sp>
          <p:nvSpPr>
            <p:cNvPr id="108" name="テキスト ボックス 107">
              <a:extLst>
                <a:ext uri="{FF2B5EF4-FFF2-40B4-BE49-F238E27FC236}">
                  <a16:creationId xmlns="" xmlns:a16="http://schemas.microsoft.com/office/drawing/2014/main" id="{2DBC37BF-7503-4DC5-B134-597A88D9B837}"/>
                </a:ext>
              </a:extLst>
            </p:cNvPr>
            <p:cNvSpPr txBox="1"/>
            <p:nvPr/>
          </p:nvSpPr>
          <p:spPr>
            <a:xfrm rot="16200000">
              <a:off x="5106277" y="1380941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="" xmlns:a16="http://schemas.microsoft.com/office/drawing/2014/main" id="{45F5E645-9506-41E0-90A0-B96F6210FB71}"/>
                </a:ext>
              </a:extLst>
            </p:cNvPr>
            <p:cNvSpPr txBox="1"/>
            <p:nvPr/>
          </p:nvSpPr>
          <p:spPr>
            <a:xfrm rot="16200000">
              <a:off x="4993745" y="1452869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="" xmlns:a16="http://schemas.microsoft.com/office/drawing/2014/main" id="{4502A94F-9CA7-495A-9357-46F00F9D0896}"/>
                </a:ext>
              </a:extLst>
            </p:cNvPr>
            <p:cNvSpPr txBox="1"/>
            <p:nvPr/>
          </p:nvSpPr>
          <p:spPr>
            <a:xfrm rot="16200000">
              <a:off x="4845653" y="1445361"/>
              <a:ext cx="869894" cy="261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="" xmlns:a16="http://schemas.microsoft.com/office/drawing/2014/main" id="{A9342E98-75B1-496D-8157-386038099DC3}"/>
                </a:ext>
              </a:extLst>
            </p:cNvPr>
            <p:cNvSpPr txBox="1"/>
            <p:nvPr/>
          </p:nvSpPr>
          <p:spPr>
            <a:xfrm rot="16200000">
              <a:off x="5290737" y="1380940"/>
              <a:ext cx="1013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="" xmlns:a16="http://schemas.microsoft.com/office/drawing/2014/main" id="{565A04FB-B87D-48DF-BDCF-C5BF10E1ECC7}"/>
                </a:ext>
              </a:extLst>
            </p:cNvPr>
            <p:cNvSpPr txBox="1"/>
            <p:nvPr/>
          </p:nvSpPr>
          <p:spPr>
            <a:xfrm rot="16200000">
              <a:off x="5830386" y="1382594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="" xmlns:a16="http://schemas.microsoft.com/office/drawing/2014/main" id="{AF37D5AC-5022-4B0B-B1DD-B145448FBEE5}"/>
                </a:ext>
              </a:extLst>
            </p:cNvPr>
            <p:cNvSpPr txBox="1"/>
            <p:nvPr/>
          </p:nvSpPr>
          <p:spPr>
            <a:xfrm rot="16200000">
              <a:off x="5713307" y="1454522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="" xmlns:a16="http://schemas.microsoft.com/office/drawing/2014/main" id="{E304EA65-A5B3-4926-A131-971AF84D8D83}"/>
                </a:ext>
              </a:extLst>
            </p:cNvPr>
            <p:cNvSpPr txBox="1"/>
            <p:nvPr/>
          </p:nvSpPr>
          <p:spPr>
            <a:xfrm rot="16200000">
              <a:off x="5547032" y="1447014"/>
              <a:ext cx="869894" cy="261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="" xmlns:a16="http://schemas.microsoft.com/office/drawing/2014/main" id="{677136B0-0BF8-4B28-9E02-CC86422E9905}"/>
                </a:ext>
              </a:extLst>
            </p:cNvPr>
            <p:cNvSpPr txBox="1"/>
            <p:nvPr/>
          </p:nvSpPr>
          <p:spPr>
            <a:xfrm rot="16200000">
              <a:off x="6001206" y="1382593"/>
              <a:ext cx="1013752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</p:grpSp>
      <p:sp>
        <p:nvSpPr>
          <p:cNvPr id="116" name="テキスト ボックス 115">
            <a:extLst>
              <a:ext uri="{FF2B5EF4-FFF2-40B4-BE49-F238E27FC236}">
                <a16:creationId xmlns="" xmlns:a16="http://schemas.microsoft.com/office/drawing/2014/main" id="{3054889A-76D5-4C37-AE5E-027958939E4F}"/>
              </a:ext>
            </a:extLst>
          </p:cNvPr>
          <p:cNvSpPr txBox="1"/>
          <p:nvPr/>
        </p:nvSpPr>
        <p:spPr>
          <a:xfrm>
            <a:off x="9695113" y="656396"/>
            <a:ext cx="80491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直線コネクタ 116">
            <a:extLst>
              <a:ext uri="{FF2B5EF4-FFF2-40B4-BE49-F238E27FC236}">
                <a16:creationId xmlns="" xmlns:a16="http://schemas.microsoft.com/office/drawing/2014/main" id="{8217CDDF-6079-4EF6-9210-17674961A9BE}"/>
              </a:ext>
            </a:extLst>
          </p:cNvPr>
          <p:cNvCxnSpPr>
            <a:cxnSpLocks/>
          </p:cNvCxnSpPr>
          <p:nvPr/>
        </p:nvCxnSpPr>
        <p:spPr>
          <a:xfrm>
            <a:off x="9809568" y="1059757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テキスト ボックス 117">
            <a:extLst>
              <a:ext uri="{FF2B5EF4-FFF2-40B4-BE49-F238E27FC236}">
                <a16:creationId xmlns="" xmlns:a16="http://schemas.microsoft.com/office/drawing/2014/main" id="{455331CC-A737-4F2E-AE76-95FA8F1794EF}"/>
              </a:ext>
            </a:extLst>
          </p:cNvPr>
          <p:cNvSpPr txBox="1"/>
          <p:nvPr/>
        </p:nvSpPr>
        <p:spPr>
          <a:xfrm>
            <a:off x="413266" y="822574"/>
            <a:ext cx="8049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直線コネクタ 118">
            <a:extLst>
              <a:ext uri="{FF2B5EF4-FFF2-40B4-BE49-F238E27FC236}">
                <a16:creationId xmlns="" xmlns:a16="http://schemas.microsoft.com/office/drawing/2014/main" id="{31CA9C37-F595-4B47-84FE-79D63D1155EB}"/>
              </a:ext>
            </a:extLst>
          </p:cNvPr>
          <p:cNvCxnSpPr>
            <a:cxnSpLocks/>
          </p:cNvCxnSpPr>
          <p:nvPr/>
        </p:nvCxnSpPr>
        <p:spPr>
          <a:xfrm>
            <a:off x="527721" y="1071393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0" name="グループ化 119">
            <a:extLst>
              <a:ext uri="{FF2B5EF4-FFF2-40B4-BE49-F238E27FC236}">
                <a16:creationId xmlns="" xmlns:a16="http://schemas.microsoft.com/office/drawing/2014/main" id="{6766503F-47D0-41E7-AEAF-BC5700C6B9B4}"/>
              </a:ext>
            </a:extLst>
          </p:cNvPr>
          <p:cNvGrpSpPr/>
          <p:nvPr/>
        </p:nvGrpSpPr>
        <p:grpSpPr>
          <a:xfrm>
            <a:off x="489286" y="983252"/>
            <a:ext cx="1256999" cy="1015405"/>
            <a:chOff x="5149981" y="997175"/>
            <a:chExt cx="1481212" cy="1015405"/>
          </a:xfrm>
        </p:grpSpPr>
        <p:sp>
          <p:nvSpPr>
            <p:cNvPr id="121" name="テキスト ボックス 120">
              <a:extLst>
                <a:ext uri="{FF2B5EF4-FFF2-40B4-BE49-F238E27FC236}">
                  <a16:creationId xmlns="" xmlns:a16="http://schemas.microsoft.com/office/drawing/2014/main" id="{DFFAB346-D963-4061-B963-939D493869DE}"/>
                </a:ext>
              </a:extLst>
            </p:cNvPr>
            <p:cNvSpPr txBox="1"/>
            <p:nvPr/>
          </p:nvSpPr>
          <p:spPr>
            <a:xfrm rot="16200000">
              <a:off x="5106277" y="1380941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="" xmlns:a16="http://schemas.microsoft.com/office/drawing/2014/main" id="{98E80418-339D-4AC0-80F2-2302A09B28AE}"/>
                </a:ext>
              </a:extLst>
            </p:cNvPr>
            <p:cNvSpPr txBox="1"/>
            <p:nvPr/>
          </p:nvSpPr>
          <p:spPr>
            <a:xfrm rot="16200000">
              <a:off x="4993745" y="1452869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="" xmlns:a16="http://schemas.microsoft.com/office/drawing/2014/main" id="{C5C4684D-57E0-4E13-8366-57FAD396CA67}"/>
                </a:ext>
              </a:extLst>
            </p:cNvPr>
            <p:cNvSpPr txBox="1"/>
            <p:nvPr/>
          </p:nvSpPr>
          <p:spPr>
            <a:xfrm rot="16200000">
              <a:off x="4845653" y="1445361"/>
              <a:ext cx="869894" cy="261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="" xmlns:a16="http://schemas.microsoft.com/office/drawing/2014/main" id="{6245AC25-B119-4396-B427-75ADE4D22455}"/>
                </a:ext>
              </a:extLst>
            </p:cNvPr>
            <p:cNvSpPr txBox="1"/>
            <p:nvPr/>
          </p:nvSpPr>
          <p:spPr>
            <a:xfrm rot="16200000">
              <a:off x="5290737" y="1380940"/>
              <a:ext cx="1013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="" xmlns:a16="http://schemas.microsoft.com/office/drawing/2014/main" id="{C4601AAE-E668-4FA6-A5F8-7C027E375810}"/>
                </a:ext>
              </a:extLst>
            </p:cNvPr>
            <p:cNvSpPr txBox="1"/>
            <p:nvPr/>
          </p:nvSpPr>
          <p:spPr>
            <a:xfrm rot="16200000">
              <a:off x="5830386" y="1382594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="" xmlns:a16="http://schemas.microsoft.com/office/drawing/2014/main" id="{370F8C34-05B3-49B6-82BC-AB3E3A31CA49}"/>
                </a:ext>
              </a:extLst>
            </p:cNvPr>
            <p:cNvSpPr txBox="1"/>
            <p:nvPr/>
          </p:nvSpPr>
          <p:spPr>
            <a:xfrm rot="16200000">
              <a:off x="5713307" y="1454522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="" xmlns:a16="http://schemas.microsoft.com/office/drawing/2014/main" id="{8BFCE108-D0BE-466C-BB1B-4D890F89A69D}"/>
                </a:ext>
              </a:extLst>
            </p:cNvPr>
            <p:cNvSpPr txBox="1"/>
            <p:nvPr/>
          </p:nvSpPr>
          <p:spPr>
            <a:xfrm rot="16200000">
              <a:off x="5547032" y="1447014"/>
              <a:ext cx="869894" cy="261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="" xmlns:a16="http://schemas.microsoft.com/office/drawing/2014/main" id="{4109E9F4-2F79-4CCE-A787-FC0C8DE2FD29}"/>
                </a:ext>
              </a:extLst>
            </p:cNvPr>
            <p:cNvSpPr txBox="1"/>
            <p:nvPr/>
          </p:nvSpPr>
          <p:spPr>
            <a:xfrm rot="16200000">
              <a:off x="6001206" y="1382593"/>
              <a:ext cx="1013752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</p:grpSp>
      <p:sp>
        <p:nvSpPr>
          <p:cNvPr id="129" name="テキスト ボックス 128">
            <a:extLst>
              <a:ext uri="{FF2B5EF4-FFF2-40B4-BE49-F238E27FC236}">
                <a16:creationId xmlns="" xmlns:a16="http://schemas.microsoft.com/office/drawing/2014/main" id="{E67F13F3-D91B-4CB8-A4FA-60E07D3A30F1}"/>
              </a:ext>
            </a:extLst>
          </p:cNvPr>
          <p:cNvSpPr txBox="1"/>
          <p:nvPr/>
        </p:nvSpPr>
        <p:spPr>
          <a:xfrm>
            <a:off x="1061857" y="822574"/>
            <a:ext cx="8049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線コネクタ 129">
            <a:extLst>
              <a:ext uri="{FF2B5EF4-FFF2-40B4-BE49-F238E27FC236}">
                <a16:creationId xmlns="" xmlns:a16="http://schemas.microsoft.com/office/drawing/2014/main" id="{FD43E83D-44D6-4306-A90D-F0E1E554AC89}"/>
              </a:ext>
            </a:extLst>
          </p:cNvPr>
          <p:cNvCxnSpPr>
            <a:cxnSpLocks/>
          </p:cNvCxnSpPr>
          <p:nvPr/>
        </p:nvCxnSpPr>
        <p:spPr>
          <a:xfrm>
            <a:off x="1176312" y="1068579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>
            <a:extLst>
              <a:ext uri="{FF2B5EF4-FFF2-40B4-BE49-F238E27FC236}">
                <a16:creationId xmlns="" xmlns:a16="http://schemas.microsoft.com/office/drawing/2014/main" id="{BB3A7446-7D0C-4F1A-BD6D-D8B565D18924}"/>
              </a:ext>
            </a:extLst>
          </p:cNvPr>
          <p:cNvSpPr txBox="1"/>
          <p:nvPr/>
        </p:nvSpPr>
        <p:spPr>
          <a:xfrm>
            <a:off x="2943323" y="823680"/>
            <a:ext cx="8049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線コネクタ 131">
            <a:extLst>
              <a:ext uri="{FF2B5EF4-FFF2-40B4-BE49-F238E27FC236}">
                <a16:creationId xmlns="" xmlns:a16="http://schemas.microsoft.com/office/drawing/2014/main" id="{C29FD477-6FAD-4E77-B23A-1A3798ACDC0A}"/>
              </a:ext>
            </a:extLst>
          </p:cNvPr>
          <p:cNvCxnSpPr>
            <a:cxnSpLocks/>
          </p:cNvCxnSpPr>
          <p:nvPr/>
        </p:nvCxnSpPr>
        <p:spPr>
          <a:xfrm>
            <a:off x="3057778" y="1072499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3" name="グループ化 132">
            <a:extLst>
              <a:ext uri="{FF2B5EF4-FFF2-40B4-BE49-F238E27FC236}">
                <a16:creationId xmlns="" xmlns:a16="http://schemas.microsoft.com/office/drawing/2014/main" id="{11E0140C-7E75-48DF-8F0D-670DD279A934}"/>
              </a:ext>
            </a:extLst>
          </p:cNvPr>
          <p:cNvGrpSpPr/>
          <p:nvPr/>
        </p:nvGrpSpPr>
        <p:grpSpPr>
          <a:xfrm>
            <a:off x="3019343" y="984358"/>
            <a:ext cx="1256999" cy="1015405"/>
            <a:chOff x="5149981" y="997175"/>
            <a:chExt cx="1481212" cy="1015405"/>
          </a:xfrm>
        </p:grpSpPr>
        <p:sp>
          <p:nvSpPr>
            <p:cNvPr id="134" name="テキスト ボックス 133">
              <a:extLst>
                <a:ext uri="{FF2B5EF4-FFF2-40B4-BE49-F238E27FC236}">
                  <a16:creationId xmlns="" xmlns:a16="http://schemas.microsoft.com/office/drawing/2014/main" id="{6653C04C-AFE8-4EBB-AB74-725D0249076E}"/>
                </a:ext>
              </a:extLst>
            </p:cNvPr>
            <p:cNvSpPr txBox="1"/>
            <p:nvPr/>
          </p:nvSpPr>
          <p:spPr>
            <a:xfrm rot="16200000">
              <a:off x="5106277" y="1380941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="" xmlns:a16="http://schemas.microsoft.com/office/drawing/2014/main" id="{C582D375-C027-4D0D-8B5D-63815E876AF3}"/>
                </a:ext>
              </a:extLst>
            </p:cNvPr>
            <p:cNvSpPr txBox="1"/>
            <p:nvPr/>
          </p:nvSpPr>
          <p:spPr>
            <a:xfrm rot="16200000">
              <a:off x="4993745" y="1452869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="" xmlns:a16="http://schemas.microsoft.com/office/drawing/2014/main" id="{4552413B-5AAC-4DE1-8BAD-77050EB1FFD6}"/>
                </a:ext>
              </a:extLst>
            </p:cNvPr>
            <p:cNvSpPr txBox="1"/>
            <p:nvPr/>
          </p:nvSpPr>
          <p:spPr>
            <a:xfrm rot="16200000">
              <a:off x="4845653" y="1445361"/>
              <a:ext cx="869894" cy="2612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="" xmlns:a16="http://schemas.microsoft.com/office/drawing/2014/main" id="{BC58124B-028B-427C-B9A2-4CEF095C1AF4}"/>
                </a:ext>
              </a:extLst>
            </p:cNvPr>
            <p:cNvSpPr txBox="1"/>
            <p:nvPr/>
          </p:nvSpPr>
          <p:spPr>
            <a:xfrm rot="16200000">
              <a:off x="5290737" y="1380940"/>
              <a:ext cx="10137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="" xmlns:a16="http://schemas.microsoft.com/office/drawing/2014/main" id="{EE150CC7-BC9A-4157-9191-BBFD9A34DBB4}"/>
                </a:ext>
              </a:extLst>
            </p:cNvPr>
            <p:cNvSpPr txBox="1"/>
            <p:nvPr/>
          </p:nvSpPr>
          <p:spPr>
            <a:xfrm rot="16200000">
              <a:off x="5830386" y="1382594"/>
              <a:ext cx="1013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="" xmlns:a16="http://schemas.microsoft.com/office/drawing/2014/main" id="{533B247F-23FB-4521-B5B5-837BE0886D60}"/>
                </a:ext>
              </a:extLst>
            </p:cNvPr>
            <p:cNvSpPr txBox="1"/>
            <p:nvPr/>
          </p:nvSpPr>
          <p:spPr>
            <a:xfrm rot="16200000">
              <a:off x="5713307" y="1454522"/>
              <a:ext cx="8698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control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="" xmlns:a16="http://schemas.microsoft.com/office/drawing/2014/main" id="{1AE3DFA5-999F-4AD0-8BA4-645B84E12D87}"/>
                </a:ext>
              </a:extLst>
            </p:cNvPr>
            <p:cNvSpPr txBox="1"/>
            <p:nvPr/>
          </p:nvSpPr>
          <p:spPr>
            <a:xfrm rot="16200000">
              <a:off x="5547032" y="1447014"/>
              <a:ext cx="869894" cy="2612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="" xmlns:a16="http://schemas.microsoft.com/office/drawing/2014/main" id="{AFE1073D-2B99-4D4B-AF9A-0E4E00CD0799}"/>
                </a:ext>
              </a:extLst>
            </p:cNvPr>
            <p:cNvSpPr txBox="1"/>
            <p:nvPr/>
          </p:nvSpPr>
          <p:spPr>
            <a:xfrm rot="16200000">
              <a:off x="6001206" y="1382593"/>
              <a:ext cx="1013752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-EHHADH</a:t>
              </a:r>
              <a:r>
                <a: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</p:grpSp>
      <p:sp>
        <p:nvSpPr>
          <p:cNvPr id="142" name="テキスト ボックス 141">
            <a:extLst>
              <a:ext uri="{FF2B5EF4-FFF2-40B4-BE49-F238E27FC236}">
                <a16:creationId xmlns="" xmlns:a16="http://schemas.microsoft.com/office/drawing/2014/main" id="{E4971403-9187-4872-ABAE-FF9D943791B6}"/>
              </a:ext>
            </a:extLst>
          </p:cNvPr>
          <p:cNvSpPr txBox="1"/>
          <p:nvPr/>
        </p:nvSpPr>
        <p:spPr>
          <a:xfrm>
            <a:off x="3591914" y="823680"/>
            <a:ext cx="8049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直線コネクタ 142">
            <a:extLst>
              <a:ext uri="{FF2B5EF4-FFF2-40B4-BE49-F238E27FC236}">
                <a16:creationId xmlns="" xmlns:a16="http://schemas.microsoft.com/office/drawing/2014/main" id="{E2462C8F-11B7-4F59-8F98-1B7769F3963D}"/>
              </a:ext>
            </a:extLst>
          </p:cNvPr>
          <p:cNvCxnSpPr>
            <a:cxnSpLocks/>
          </p:cNvCxnSpPr>
          <p:nvPr/>
        </p:nvCxnSpPr>
        <p:spPr>
          <a:xfrm>
            <a:off x="3706369" y="1069685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157664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屋内, 写真, 座る, 冷蔵庫 が含まれている画像&#10;&#10;自動的に生成された説明">
            <a:extLst>
              <a:ext uri="{FF2B5EF4-FFF2-40B4-BE49-F238E27FC236}">
                <a16:creationId xmlns="" xmlns:a16="http://schemas.microsoft.com/office/drawing/2014/main" id="{42B106D7-411A-4665-947D-DF43A149F5C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77" t="34629" r="26576" b="22749"/>
          <a:stretch/>
        </p:blipFill>
        <p:spPr>
          <a:xfrm>
            <a:off x="4435147" y="2095974"/>
            <a:ext cx="3191096" cy="3094580"/>
          </a:xfrm>
          <a:prstGeom prst="rect">
            <a:avLst/>
          </a:prstGeom>
        </p:spPr>
      </p:pic>
      <p:pic>
        <p:nvPicPr>
          <p:cNvPr id="2" name="図 1" descr="グラフ が含まれている画像&#10;&#10;自動的に生成された説明">
            <a:extLst>
              <a:ext uri="{FF2B5EF4-FFF2-40B4-BE49-F238E27FC236}">
                <a16:creationId xmlns="" xmlns:a16="http://schemas.microsoft.com/office/drawing/2014/main" id="{70D9354E-8EBA-4F6E-AB74-1E5D4780D4D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75" t="34493" r="26928" b="20674"/>
          <a:stretch/>
        </p:blipFill>
        <p:spPr>
          <a:xfrm>
            <a:off x="732908" y="2121515"/>
            <a:ext cx="3191096" cy="3094580"/>
          </a:xfrm>
          <a:prstGeom prst="rect">
            <a:avLst/>
          </a:prstGeom>
        </p:spPr>
      </p:pic>
      <p:sp>
        <p:nvSpPr>
          <p:cNvPr id="63" name="テキスト ボックス 62">
            <a:extLst>
              <a:ext uri="{FF2B5EF4-FFF2-40B4-BE49-F238E27FC236}">
                <a16:creationId xmlns="" xmlns:a16="http://schemas.microsoft.com/office/drawing/2014/main" id="{B667EA56-337F-440A-AC9F-B63E5490BAB8}"/>
              </a:ext>
            </a:extLst>
          </p:cNvPr>
          <p:cNvSpPr txBox="1"/>
          <p:nvPr/>
        </p:nvSpPr>
        <p:spPr>
          <a:xfrm>
            <a:off x="234561" y="232253"/>
            <a:ext cx="18339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kumimoji="1"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6F</a:t>
            </a:r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="" xmlns:a16="http://schemas.microsoft.com/office/drawing/2014/main" id="{9E93624F-1AB0-4573-9D50-09E0ECD86240}"/>
              </a:ext>
            </a:extLst>
          </p:cNvPr>
          <p:cNvSpPr txBox="1"/>
          <p:nvPr/>
        </p:nvSpPr>
        <p:spPr>
          <a:xfrm>
            <a:off x="8324047" y="2853637"/>
            <a:ext cx="1212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aved PARP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="" xmlns:a16="http://schemas.microsoft.com/office/drawing/2014/main" id="{F49F2224-A1AD-44C1-BE72-5689A4039494}"/>
              </a:ext>
            </a:extLst>
          </p:cNvPr>
          <p:cNvSpPr txBox="1"/>
          <p:nvPr/>
        </p:nvSpPr>
        <p:spPr>
          <a:xfrm>
            <a:off x="7766913" y="2853637"/>
            <a:ext cx="650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9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="" xmlns:a16="http://schemas.microsoft.com/office/drawing/2014/main" id="{1D9577C7-6C7E-4B24-A7C1-5A010FB4CC7B}"/>
              </a:ext>
            </a:extLst>
          </p:cNvPr>
          <p:cNvSpPr txBox="1"/>
          <p:nvPr/>
        </p:nvSpPr>
        <p:spPr>
          <a:xfrm>
            <a:off x="8329745" y="3319182"/>
            <a:ext cx="8243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="" xmlns:a16="http://schemas.microsoft.com/office/drawing/2014/main" id="{EB1D70AE-66F6-46E6-92DD-F9C5D0C3939E}"/>
              </a:ext>
            </a:extLst>
          </p:cNvPr>
          <p:cNvSpPr txBox="1"/>
          <p:nvPr/>
        </p:nvSpPr>
        <p:spPr>
          <a:xfrm>
            <a:off x="7774317" y="3319182"/>
            <a:ext cx="6509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2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正方形/長方形 80">
            <a:extLst>
              <a:ext uri="{FF2B5EF4-FFF2-40B4-BE49-F238E27FC236}">
                <a16:creationId xmlns="" xmlns:a16="http://schemas.microsoft.com/office/drawing/2014/main" id="{3202881B-3B2E-452A-8D72-0FDCA7EAF489}"/>
              </a:ext>
            </a:extLst>
          </p:cNvPr>
          <p:cNvSpPr/>
          <p:nvPr/>
        </p:nvSpPr>
        <p:spPr>
          <a:xfrm>
            <a:off x="1544715" y="3332831"/>
            <a:ext cx="763477" cy="2326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6A12A3C8-B28A-4CCB-9B02-5620300FC2FA}"/>
              </a:ext>
            </a:extLst>
          </p:cNvPr>
          <p:cNvSpPr txBox="1"/>
          <p:nvPr/>
        </p:nvSpPr>
        <p:spPr>
          <a:xfrm>
            <a:off x="4551753" y="5241397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1min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="" xmlns:a16="http://schemas.microsoft.com/office/drawing/2014/main" id="{D0D94427-6C12-4452-B304-FE0AE2AF5353}"/>
              </a:ext>
            </a:extLst>
          </p:cNvPr>
          <p:cNvSpPr txBox="1"/>
          <p:nvPr/>
        </p:nvSpPr>
        <p:spPr>
          <a:xfrm>
            <a:off x="956673" y="5251485"/>
            <a:ext cx="17185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Exposure time 5sec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="" xmlns:a16="http://schemas.microsoft.com/office/drawing/2014/main" id="{82091AF3-3439-4A8B-B09D-887B5C4FDD3F}"/>
              </a:ext>
            </a:extLst>
          </p:cNvPr>
          <p:cNvSpPr/>
          <p:nvPr/>
        </p:nvSpPr>
        <p:spPr>
          <a:xfrm>
            <a:off x="2316017" y="3332831"/>
            <a:ext cx="763477" cy="2326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="" xmlns:a16="http://schemas.microsoft.com/office/drawing/2014/main" id="{CD0FD461-D9C9-4E93-A50C-D00E832B2028}"/>
              </a:ext>
            </a:extLst>
          </p:cNvPr>
          <p:cNvSpPr/>
          <p:nvPr/>
        </p:nvSpPr>
        <p:spPr>
          <a:xfrm>
            <a:off x="5132774" y="2781917"/>
            <a:ext cx="763477" cy="2326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="" xmlns:a16="http://schemas.microsoft.com/office/drawing/2014/main" id="{87BAD8C2-B5F2-4476-9A6A-82D84112EB33}"/>
              </a:ext>
            </a:extLst>
          </p:cNvPr>
          <p:cNvSpPr/>
          <p:nvPr/>
        </p:nvSpPr>
        <p:spPr>
          <a:xfrm>
            <a:off x="5904076" y="2781917"/>
            <a:ext cx="763477" cy="2326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8" name="テキスト ボックス 67">
            <a:extLst>
              <a:ext uri="{FF2B5EF4-FFF2-40B4-BE49-F238E27FC236}">
                <a16:creationId xmlns="" xmlns:a16="http://schemas.microsoft.com/office/drawing/2014/main" id="{1F4D1648-7F89-42E7-B949-BF448E4FDA5A}"/>
              </a:ext>
            </a:extLst>
          </p:cNvPr>
          <p:cNvSpPr txBox="1"/>
          <p:nvPr/>
        </p:nvSpPr>
        <p:spPr>
          <a:xfrm rot="16200000">
            <a:off x="1512229" y="1380052"/>
            <a:ext cx="1013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="" xmlns:a16="http://schemas.microsoft.com/office/drawing/2014/main" id="{3991C6CD-AA57-4F4B-83DA-2841E0457E87}"/>
              </a:ext>
            </a:extLst>
          </p:cNvPr>
          <p:cNvSpPr txBox="1"/>
          <p:nvPr/>
        </p:nvSpPr>
        <p:spPr>
          <a:xfrm rot="16200000">
            <a:off x="1399697" y="1451980"/>
            <a:ext cx="869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="" xmlns:a16="http://schemas.microsoft.com/office/drawing/2014/main" id="{F328186F-C4D6-489A-AC01-E7A4CEA544B9}"/>
              </a:ext>
            </a:extLst>
          </p:cNvPr>
          <p:cNvSpPr txBox="1"/>
          <p:nvPr/>
        </p:nvSpPr>
        <p:spPr>
          <a:xfrm rot="16200000">
            <a:off x="1215237" y="1444472"/>
            <a:ext cx="869894" cy="261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="" xmlns:a16="http://schemas.microsoft.com/office/drawing/2014/main" id="{A6811A74-F3BD-4137-B755-EB461D736F13}"/>
              </a:ext>
            </a:extLst>
          </p:cNvPr>
          <p:cNvSpPr txBox="1"/>
          <p:nvPr/>
        </p:nvSpPr>
        <p:spPr>
          <a:xfrm rot="16200000">
            <a:off x="1696689" y="1380051"/>
            <a:ext cx="1013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</a:p>
        </p:txBody>
      </p:sp>
      <p:sp>
        <p:nvSpPr>
          <p:cNvPr id="60" name="テキスト ボックス 59">
            <a:extLst>
              <a:ext uri="{FF2B5EF4-FFF2-40B4-BE49-F238E27FC236}">
                <a16:creationId xmlns="" xmlns:a16="http://schemas.microsoft.com/office/drawing/2014/main" id="{9330F473-CC3C-4BA7-9379-3F3EB40D9E0C}"/>
              </a:ext>
            </a:extLst>
          </p:cNvPr>
          <p:cNvSpPr txBox="1"/>
          <p:nvPr/>
        </p:nvSpPr>
        <p:spPr>
          <a:xfrm>
            <a:off x="1557256" y="664970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線コネクタ 61">
            <a:extLst>
              <a:ext uri="{FF2B5EF4-FFF2-40B4-BE49-F238E27FC236}">
                <a16:creationId xmlns="" xmlns:a16="http://schemas.microsoft.com/office/drawing/2014/main" id="{7226DDC3-B314-4480-AC66-63FA37BFB76E}"/>
              </a:ext>
            </a:extLst>
          </p:cNvPr>
          <p:cNvCxnSpPr>
            <a:cxnSpLocks/>
          </p:cNvCxnSpPr>
          <p:nvPr/>
        </p:nvCxnSpPr>
        <p:spPr>
          <a:xfrm>
            <a:off x="1630277" y="1068331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テキスト ボックス 79">
            <a:extLst>
              <a:ext uri="{FF2B5EF4-FFF2-40B4-BE49-F238E27FC236}">
                <a16:creationId xmlns="" xmlns:a16="http://schemas.microsoft.com/office/drawing/2014/main" id="{9E096133-8AAE-46E4-A5FC-B4A017468138}"/>
              </a:ext>
            </a:extLst>
          </p:cNvPr>
          <p:cNvSpPr txBox="1"/>
          <p:nvPr/>
        </p:nvSpPr>
        <p:spPr>
          <a:xfrm rot="16200000">
            <a:off x="2272707" y="1381705"/>
            <a:ext cx="1013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="" xmlns:a16="http://schemas.microsoft.com/office/drawing/2014/main" id="{05A1DF64-0845-441F-81BC-D0DF3D6A2A21}"/>
              </a:ext>
            </a:extLst>
          </p:cNvPr>
          <p:cNvSpPr txBox="1"/>
          <p:nvPr/>
        </p:nvSpPr>
        <p:spPr>
          <a:xfrm rot="16200000">
            <a:off x="2160175" y="1453633"/>
            <a:ext cx="869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62177937-87F3-4825-AAE6-7C795244F362}"/>
              </a:ext>
            </a:extLst>
          </p:cNvPr>
          <p:cNvSpPr txBox="1"/>
          <p:nvPr/>
        </p:nvSpPr>
        <p:spPr>
          <a:xfrm rot="16200000">
            <a:off x="1975715" y="1446125"/>
            <a:ext cx="869894" cy="261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="" xmlns:a16="http://schemas.microsoft.com/office/drawing/2014/main" id="{1977891E-258B-4DD0-9A44-0EB07AD939DA}"/>
              </a:ext>
            </a:extLst>
          </p:cNvPr>
          <p:cNvSpPr txBox="1"/>
          <p:nvPr/>
        </p:nvSpPr>
        <p:spPr>
          <a:xfrm rot="16200000">
            <a:off x="2457167" y="1381704"/>
            <a:ext cx="1013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2395005A-9396-478A-B6E0-720EAA8D647B}"/>
              </a:ext>
            </a:extLst>
          </p:cNvPr>
          <p:cNvSpPr txBox="1"/>
          <p:nvPr/>
        </p:nvSpPr>
        <p:spPr>
          <a:xfrm>
            <a:off x="2317734" y="666623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線コネクタ 86">
            <a:extLst>
              <a:ext uri="{FF2B5EF4-FFF2-40B4-BE49-F238E27FC236}">
                <a16:creationId xmlns="" xmlns:a16="http://schemas.microsoft.com/office/drawing/2014/main" id="{3C5A67DF-D71A-4050-85C9-4FEAF8D7E738}"/>
              </a:ext>
            </a:extLst>
          </p:cNvPr>
          <p:cNvCxnSpPr>
            <a:cxnSpLocks/>
          </p:cNvCxnSpPr>
          <p:nvPr/>
        </p:nvCxnSpPr>
        <p:spPr>
          <a:xfrm>
            <a:off x="2390755" y="1069984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>
            <a:extLst>
              <a:ext uri="{FF2B5EF4-FFF2-40B4-BE49-F238E27FC236}">
                <a16:creationId xmlns="" xmlns:a16="http://schemas.microsoft.com/office/drawing/2014/main" id="{57E1DD23-B907-4B7C-A572-53182B3A5E1F}"/>
              </a:ext>
            </a:extLst>
          </p:cNvPr>
          <p:cNvSpPr txBox="1"/>
          <p:nvPr/>
        </p:nvSpPr>
        <p:spPr>
          <a:xfrm rot="16200000">
            <a:off x="5106277" y="1380941"/>
            <a:ext cx="1013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="" xmlns:a16="http://schemas.microsoft.com/office/drawing/2014/main" id="{289F8963-98ED-44A3-AA2C-14D1844A9BA1}"/>
              </a:ext>
            </a:extLst>
          </p:cNvPr>
          <p:cNvSpPr txBox="1"/>
          <p:nvPr/>
        </p:nvSpPr>
        <p:spPr>
          <a:xfrm rot="16200000">
            <a:off x="4993745" y="1452869"/>
            <a:ext cx="869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="" xmlns:a16="http://schemas.microsoft.com/office/drawing/2014/main" id="{25EDB3AA-98A2-4128-A467-99E76DF29387}"/>
              </a:ext>
            </a:extLst>
          </p:cNvPr>
          <p:cNvSpPr txBox="1"/>
          <p:nvPr/>
        </p:nvSpPr>
        <p:spPr>
          <a:xfrm rot="16200000">
            <a:off x="4809285" y="1445361"/>
            <a:ext cx="869894" cy="261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="" xmlns:a16="http://schemas.microsoft.com/office/drawing/2014/main" id="{BFECDF42-2091-4042-A529-4EF5EFC7A9A6}"/>
              </a:ext>
            </a:extLst>
          </p:cNvPr>
          <p:cNvSpPr txBox="1"/>
          <p:nvPr/>
        </p:nvSpPr>
        <p:spPr>
          <a:xfrm rot="16200000">
            <a:off x="5290737" y="1380940"/>
            <a:ext cx="1013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</a:p>
        </p:txBody>
      </p:sp>
      <p:sp>
        <p:nvSpPr>
          <p:cNvPr id="92" name="テキスト ボックス 91">
            <a:extLst>
              <a:ext uri="{FF2B5EF4-FFF2-40B4-BE49-F238E27FC236}">
                <a16:creationId xmlns="" xmlns:a16="http://schemas.microsoft.com/office/drawing/2014/main" id="{A5F62624-C189-4609-A67A-7CC584D43416}"/>
              </a:ext>
            </a:extLst>
          </p:cNvPr>
          <p:cNvSpPr txBox="1"/>
          <p:nvPr/>
        </p:nvSpPr>
        <p:spPr>
          <a:xfrm>
            <a:off x="5151304" y="665859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BOY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線コネクタ 92">
            <a:extLst>
              <a:ext uri="{FF2B5EF4-FFF2-40B4-BE49-F238E27FC236}">
                <a16:creationId xmlns="" xmlns:a16="http://schemas.microsoft.com/office/drawing/2014/main" id="{4D89C278-706E-4427-AD9C-BD64D5F4C6F1}"/>
              </a:ext>
            </a:extLst>
          </p:cNvPr>
          <p:cNvCxnSpPr>
            <a:cxnSpLocks/>
          </p:cNvCxnSpPr>
          <p:nvPr/>
        </p:nvCxnSpPr>
        <p:spPr>
          <a:xfrm>
            <a:off x="5224325" y="1069220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テキスト ボックス 93">
            <a:extLst>
              <a:ext uri="{FF2B5EF4-FFF2-40B4-BE49-F238E27FC236}">
                <a16:creationId xmlns="" xmlns:a16="http://schemas.microsoft.com/office/drawing/2014/main" id="{8567845F-8C32-421E-AE88-28CB7AF7B2C9}"/>
              </a:ext>
            </a:extLst>
          </p:cNvPr>
          <p:cNvSpPr txBox="1"/>
          <p:nvPr/>
        </p:nvSpPr>
        <p:spPr>
          <a:xfrm rot="16200000">
            <a:off x="5866755" y="1382594"/>
            <a:ext cx="1013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①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="" xmlns:a16="http://schemas.microsoft.com/office/drawing/2014/main" id="{865D5261-6905-44D6-89D4-2D0CEFBAC50E}"/>
              </a:ext>
            </a:extLst>
          </p:cNvPr>
          <p:cNvSpPr txBox="1"/>
          <p:nvPr/>
        </p:nvSpPr>
        <p:spPr>
          <a:xfrm rot="16200000">
            <a:off x="5754223" y="1454522"/>
            <a:ext cx="869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control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="" xmlns:a16="http://schemas.microsoft.com/office/drawing/2014/main" id="{BACD4328-A521-41E8-AA67-55875D1D400C}"/>
              </a:ext>
            </a:extLst>
          </p:cNvPr>
          <p:cNvSpPr txBox="1"/>
          <p:nvPr/>
        </p:nvSpPr>
        <p:spPr>
          <a:xfrm rot="16200000">
            <a:off x="5569763" y="1447014"/>
            <a:ext cx="869894" cy="261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="" xmlns:a16="http://schemas.microsoft.com/office/drawing/2014/main" id="{7127F822-3A65-42DC-ABB7-2DC2A154903D}"/>
              </a:ext>
            </a:extLst>
          </p:cNvPr>
          <p:cNvSpPr txBox="1"/>
          <p:nvPr/>
        </p:nvSpPr>
        <p:spPr>
          <a:xfrm rot="16200000">
            <a:off x="6051215" y="1382593"/>
            <a:ext cx="10137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EHHADH</a:t>
            </a:r>
            <a:r>
              <a: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②</a:t>
            </a:r>
          </a:p>
        </p:txBody>
      </p:sp>
      <p:sp>
        <p:nvSpPr>
          <p:cNvPr id="98" name="テキスト ボックス 97">
            <a:extLst>
              <a:ext uri="{FF2B5EF4-FFF2-40B4-BE49-F238E27FC236}">
                <a16:creationId xmlns="" xmlns:a16="http://schemas.microsoft.com/office/drawing/2014/main" id="{16EF4F3F-4930-4B03-995F-E3E477AC907C}"/>
              </a:ext>
            </a:extLst>
          </p:cNvPr>
          <p:cNvSpPr txBox="1"/>
          <p:nvPr/>
        </p:nvSpPr>
        <p:spPr>
          <a:xfrm>
            <a:off x="5911782" y="667512"/>
            <a:ext cx="7220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CDDP-R-</a:t>
            </a:r>
          </a:p>
          <a:p>
            <a:pPr algn="ctr"/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24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線コネクタ 98">
            <a:extLst>
              <a:ext uri="{FF2B5EF4-FFF2-40B4-BE49-F238E27FC236}">
                <a16:creationId xmlns="" xmlns:a16="http://schemas.microsoft.com/office/drawing/2014/main" id="{3E856344-27A8-4131-A338-BFB4FD56C77D}"/>
              </a:ext>
            </a:extLst>
          </p:cNvPr>
          <p:cNvCxnSpPr>
            <a:cxnSpLocks/>
          </p:cNvCxnSpPr>
          <p:nvPr/>
        </p:nvCxnSpPr>
        <p:spPr>
          <a:xfrm>
            <a:off x="5984803" y="1070873"/>
            <a:ext cx="57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8CFB4F7F-7604-444A-A468-326AA6E7F757}"/>
              </a:ext>
            </a:extLst>
          </p:cNvPr>
          <p:cNvSpPr txBox="1"/>
          <p:nvPr/>
        </p:nvSpPr>
        <p:spPr>
          <a:xfrm>
            <a:off x="8328009" y="2677871"/>
            <a:ext cx="1488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E5A903CF-7AF6-4410-83D2-5C24F84F005B}"/>
              </a:ext>
            </a:extLst>
          </p:cNvPr>
          <p:cNvSpPr txBox="1"/>
          <p:nvPr/>
        </p:nvSpPr>
        <p:spPr>
          <a:xfrm>
            <a:off x="7689407" y="2677871"/>
            <a:ext cx="798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6kDa</a:t>
            </a:r>
            <a:endParaRPr lang="ja-JP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4733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216</Words>
  <Application>Microsoft Office PowerPoint</Application>
  <PresentationFormat>ワイド画面</PresentationFormat>
  <Paragraphs>161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村 俊介</dc:creator>
  <cp:lastModifiedBy>榎田 英樹</cp:lastModifiedBy>
  <cp:revision>17</cp:revision>
  <dcterms:created xsi:type="dcterms:W3CDTF">2020-08-28T08:08:33Z</dcterms:created>
  <dcterms:modified xsi:type="dcterms:W3CDTF">2020-11-11T01:00:56Z</dcterms:modified>
</cp:coreProperties>
</file>